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63" r:id="rId4"/>
    <p:sldId id="259" r:id="rId5"/>
    <p:sldId id="261" r:id="rId6"/>
    <p:sldId id="262" r:id="rId7"/>
  </p:sldIdLst>
  <p:sldSz cx="10058400" cy="5741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度样式 2 - 强调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中度样式 2 - 强调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84884" autoAdjust="0"/>
  </p:normalViewPr>
  <p:slideViewPr>
    <p:cSldViewPr snapToGrid="0">
      <p:cViewPr varScale="1">
        <p:scale>
          <a:sx n="73" d="100"/>
          <a:sy n="73" d="100"/>
        </p:scale>
        <p:origin x="1068" y="60"/>
      </p:cViewPr>
      <p:guideLst>
        <p:guide orient="horz" pos="180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3">
  <dgm:title val=""/>
  <dgm:desc val=""/>
  <dgm:catLst>
    <dgm:cat type="colorful" pri="10300"/>
  </dgm:catLst>
  <dgm:styleLbl name="node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3"/>
      <a:schemeClr val="accent4"/>
    </dgm:fillClrLst>
    <dgm:linClrLst>
      <a:schemeClr val="accent3"/>
      <a:schemeClr val="accent4"/>
    </dgm:linClrLst>
    <dgm:effectClrLst/>
    <dgm:txLinClrLst/>
    <dgm:txFillClrLst/>
    <dgm:txEffectClrLst/>
  </dgm:styleLbl>
  <dgm:styleLbl name="ln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3">
        <a:alpha val="50000"/>
      </a:schemeClr>
      <a:schemeClr val="accent4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3">
        <a:tint val="50000"/>
      </a:schemeClr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3"/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158CBDB-000B-4FCA-A1BB-A34897A6BE93}" type="doc">
      <dgm:prSet loTypeId="urn:microsoft.com/office/officeart/2005/8/layout/hierarchy1" loCatId="hierarchy" qsTypeId="urn:microsoft.com/office/officeart/2005/8/quickstyle/simple1" qsCatId="simple" csTypeId="urn:microsoft.com/office/officeart/2005/8/colors/colorful3" csCatId="colorful" phldr="1"/>
      <dgm:spPr/>
      <dgm:t>
        <a:bodyPr/>
        <a:lstStyle/>
        <a:p>
          <a:endParaRPr lang="zh-CN" altLang="en-US"/>
        </a:p>
      </dgm:t>
    </dgm:pt>
    <dgm:pt modelId="{4A2E017A-87C5-4D13-B50F-2989CDDE7395}">
      <dgm:prSet phldrT="[文本]"/>
      <dgm:spPr/>
      <dgm:t>
        <a:bodyPr/>
        <a:lstStyle/>
        <a:p>
          <a:r>
            <a:rPr lang="en-US" altLang="zh-CN" b="1" dirty="0">
              <a:latin typeface="+mn-lt"/>
              <a:cs typeface="Times New Roman" panose="02020603050405020304" pitchFamily="18" charset="0"/>
            </a:rPr>
            <a:t>SUV  model</a:t>
          </a:r>
          <a:endParaRPr lang="zh-CN" altLang="en-US" b="1" dirty="0">
            <a:latin typeface="+mn-lt"/>
            <a:cs typeface="Times New Roman" panose="02020603050405020304" pitchFamily="18" charset="0"/>
          </a:endParaRPr>
        </a:p>
      </dgm:t>
    </dgm:pt>
    <dgm:pt modelId="{7F306F33-5B91-4FDD-BE71-B11DB476D685}" type="parTrans" cxnId="{2D3EF658-D323-4129-BBA0-32ACAD0C776C}">
      <dgm:prSet/>
      <dgm:spPr/>
      <dgm:t>
        <a:bodyPr/>
        <a:lstStyle/>
        <a:p>
          <a:endParaRPr lang="zh-CN" altLang="en-US"/>
        </a:p>
      </dgm:t>
    </dgm:pt>
    <dgm:pt modelId="{B6988033-822C-4B39-859D-6E5FD30A88F5}" type="sibTrans" cxnId="{2D3EF658-D323-4129-BBA0-32ACAD0C776C}">
      <dgm:prSet/>
      <dgm:spPr/>
      <dgm:t>
        <a:bodyPr/>
        <a:lstStyle/>
        <a:p>
          <a:endParaRPr lang="zh-CN" altLang="en-US"/>
        </a:p>
      </dgm:t>
    </dgm:pt>
    <dgm:pt modelId="{642C1A4A-B21C-4241-970D-E3E47EAC3F27}">
      <dgm:prSet/>
      <dgm:spPr/>
      <dgm:t>
        <a:bodyPr/>
        <a:lstStyle/>
        <a:p>
          <a:r>
            <a:rPr lang="en-US" b="1" dirty="0">
              <a:latin typeface="+mn-lt"/>
              <a:cs typeface="Times New Roman" panose="02020603050405020304" pitchFamily="18" charset="0"/>
            </a:rPr>
            <a:t>texture parameter model </a:t>
          </a:r>
          <a:endParaRPr lang="zh-CN" altLang="en-US" b="1" dirty="0">
            <a:latin typeface="+mn-lt"/>
            <a:cs typeface="Times New Roman" panose="02020603050405020304" pitchFamily="18" charset="0"/>
          </a:endParaRPr>
        </a:p>
      </dgm:t>
    </dgm:pt>
    <dgm:pt modelId="{BE9446E7-8EA6-498F-B7FC-9E254C9D2C2A}" type="parTrans" cxnId="{3E73D0E6-E395-4B9E-BFDA-36F6F666C220}">
      <dgm:prSet/>
      <dgm:spPr/>
      <dgm:t>
        <a:bodyPr/>
        <a:lstStyle/>
        <a:p>
          <a:endParaRPr lang="zh-CN" altLang="en-US"/>
        </a:p>
      </dgm:t>
    </dgm:pt>
    <dgm:pt modelId="{80138097-0E8D-4705-8B3F-D45331128EAD}" type="sibTrans" cxnId="{3E73D0E6-E395-4B9E-BFDA-36F6F666C220}">
      <dgm:prSet/>
      <dgm:spPr/>
      <dgm:t>
        <a:bodyPr/>
        <a:lstStyle/>
        <a:p>
          <a:endParaRPr lang="zh-CN" altLang="en-US"/>
        </a:p>
      </dgm:t>
    </dgm:pt>
    <dgm:pt modelId="{941B23FC-65D6-43E7-815E-B6EFC9019F80}">
      <dgm:prSet/>
      <dgm:spPr/>
      <dgm:t>
        <a:bodyPr/>
        <a:lstStyle/>
        <a:p>
          <a:r>
            <a:rPr lang="en-US" b="1" dirty="0">
              <a:latin typeface="+mn-lt"/>
              <a:cs typeface="Times New Roman" panose="02020603050405020304" pitchFamily="18" charset="0"/>
            </a:rPr>
            <a:t>PET/CT  </a:t>
          </a:r>
        </a:p>
        <a:p>
          <a:r>
            <a:rPr lang="en-US" b="1" dirty="0">
              <a:latin typeface="+mn-lt"/>
              <a:cs typeface="Times New Roman" panose="02020603050405020304" pitchFamily="18" charset="0"/>
            </a:rPr>
            <a:t>model </a:t>
          </a:r>
          <a:endParaRPr lang="zh-CN" altLang="en-US" b="1" dirty="0">
            <a:latin typeface="+mn-lt"/>
            <a:cs typeface="Times New Roman" panose="02020603050405020304" pitchFamily="18" charset="0"/>
          </a:endParaRPr>
        </a:p>
      </dgm:t>
    </dgm:pt>
    <dgm:pt modelId="{1DB8DA31-7962-4B4F-9389-50C1F0A2BE55}" type="parTrans" cxnId="{8C8488E8-C1D7-41DF-AD14-E93F8A559DA5}">
      <dgm:prSet/>
      <dgm:spPr/>
      <dgm:t>
        <a:bodyPr/>
        <a:lstStyle/>
        <a:p>
          <a:endParaRPr lang="zh-CN" altLang="en-US"/>
        </a:p>
      </dgm:t>
    </dgm:pt>
    <dgm:pt modelId="{21A89706-7190-4610-B9DF-059358B159B8}" type="sibTrans" cxnId="{8C8488E8-C1D7-41DF-AD14-E93F8A559DA5}">
      <dgm:prSet/>
      <dgm:spPr/>
      <dgm:t>
        <a:bodyPr/>
        <a:lstStyle/>
        <a:p>
          <a:endParaRPr lang="zh-CN" altLang="en-US"/>
        </a:p>
      </dgm:t>
    </dgm:pt>
    <dgm:pt modelId="{6B2A2064-5895-4BC7-9FD1-09BA7134F550}">
      <dgm:prSet/>
      <dgm:spPr/>
      <dgm:t>
        <a:bodyPr/>
        <a:lstStyle/>
        <a:p>
          <a:r>
            <a:rPr lang="en-US" b="1" dirty="0">
              <a:latin typeface="+mn-lt"/>
              <a:cs typeface="Times New Roman" panose="02020603050405020304" pitchFamily="18" charset="0"/>
            </a:rPr>
            <a:t>PET</a:t>
          </a:r>
        </a:p>
        <a:p>
          <a:r>
            <a:rPr lang="en-US" b="1" dirty="0">
              <a:latin typeface="+mn-lt"/>
              <a:cs typeface="Times New Roman" panose="02020603050405020304" pitchFamily="18" charset="0"/>
            </a:rPr>
            <a:t>model</a:t>
          </a:r>
          <a:endParaRPr lang="zh-CN" altLang="en-US" b="1" dirty="0">
            <a:latin typeface="+mn-lt"/>
            <a:cs typeface="Times New Roman" panose="02020603050405020304" pitchFamily="18" charset="0"/>
          </a:endParaRPr>
        </a:p>
      </dgm:t>
    </dgm:pt>
    <dgm:pt modelId="{D313F3A2-A743-4936-A3C4-512C49AE7FA1}" type="parTrans" cxnId="{9B78BF0F-8875-41F6-8431-C7AD3677733E}">
      <dgm:prSet/>
      <dgm:spPr/>
      <dgm:t>
        <a:bodyPr/>
        <a:lstStyle/>
        <a:p>
          <a:endParaRPr lang="zh-CN" altLang="en-US"/>
        </a:p>
      </dgm:t>
    </dgm:pt>
    <dgm:pt modelId="{944813D9-F30C-4F71-9B1A-13F64439AB32}" type="sibTrans" cxnId="{9B78BF0F-8875-41F6-8431-C7AD3677733E}">
      <dgm:prSet/>
      <dgm:spPr/>
      <dgm:t>
        <a:bodyPr/>
        <a:lstStyle/>
        <a:p>
          <a:endParaRPr lang="zh-CN" altLang="en-US"/>
        </a:p>
      </dgm:t>
    </dgm:pt>
    <dgm:pt modelId="{9FFC6F56-5642-4BF1-BC1C-712E43F26656}">
      <dgm:prSet phldrT="[文本]"/>
      <dgm:spPr/>
      <dgm:t>
        <a:bodyPr/>
        <a:lstStyle/>
        <a:p>
          <a:r>
            <a:rPr lang="en-US" b="1" i="0" dirty="0"/>
            <a:t>Prediction model</a:t>
          </a:r>
          <a:endParaRPr lang="zh-CN" altLang="en-US" b="1" dirty="0"/>
        </a:p>
      </dgm:t>
    </dgm:pt>
    <dgm:pt modelId="{9BD69410-8420-4834-9868-8C560D4C7704}" type="sibTrans" cxnId="{F9D5F9EE-6E4C-43A4-88A9-990E7E75EFFB}">
      <dgm:prSet/>
      <dgm:spPr/>
      <dgm:t>
        <a:bodyPr/>
        <a:lstStyle/>
        <a:p>
          <a:endParaRPr lang="zh-CN" altLang="en-US"/>
        </a:p>
      </dgm:t>
    </dgm:pt>
    <dgm:pt modelId="{ECD89EAE-0789-4D74-8B1E-03CF37751A33}" type="parTrans" cxnId="{F9D5F9EE-6E4C-43A4-88A9-990E7E75EFFB}">
      <dgm:prSet/>
      <dgm:spPr/>
      <dgm:t>
        <a:bodyPr/>
        <a:lstStyle/>
        <a:p>
          <a:endParaRPr lang="zh-CN" altLang="en-US"/>
        </a:p>
      </dgm:t>
    </dgm:pt>
    <dgm:pt modelId="{1B95FC3D-EF4A-4B3B-A91C-1CD485F15347}">
      <dgm:prSet/>
      <dgm:spPr/>
      <dgm:t>
        <a:bodyPr/>
        <a:lstStyle/>
        <a:p>
          <a:r>
            <a:rPr lang="en-US" altLang="zh-CN" b="1" dirty="0" err="1">
              <a:latin typeface="+mn-lt"/>
              <a:cs typeface="Times New Roman" panose="02020603050405020304" pitchFamily="18" charset="0"/>
            </a:rPr>
            <a:t>SUVmax</a:t>
          </a:r>
          <a:r>
            <a:rPr lang="en-US" altLang="zh-CN" b="1" dirty="0">
              <a:latin typeface="+mn-lt"/>
              <a:cs typeface="Times New Roman" panose="02020603050405020304" pitchFamily="18" charset="0"/>
            </a:rPr>
            <a:t> model</a:t>
          </a:r>
          <a:endParaRPr lang="zh-CN" altLang="en-US" b="1" dirty="0">
            <a:latin typeface="+mn-lt"/>
            <a:cs typeface="Times New Roman" panose="02020603050405020304" pitchFamily="18" charset="0"/>
          </a:endParaRPr>
        </a:p>
      </dgm:t>
    </dgm:pt>
    <dgm:pt modelId="{0BE0BD1C-895E-4021-8E11-320E60600831}" type="parTrans" cxnId="{E32F9B9D-506D-4943-8DBA-EE8AA09A056C}">
      <dgm:prSet/>
      <dgm:spPr/>
      <dgm:t>
        <a:bodyPr/>
        <a:lstStyle/>
        <a:p>
          <a:endParaRPr lang="zh-CN" altLang="en-US"/>
        </a:p>
      </dgm:t>
    </dgm:pt>
    <dgm:pt modelId="{6356A353-3EB8-4F1E-A24E-A26AEEFD1C77}" type="sibTrans" cxnId="{E32F9B9D-506D-4943-8DBA-EE8AA09A056C}">
      <dgm:prSet/>
      <dgm:spPr/>
      <dgm:t>
        <a:bodyPr/>
        <a:lstStyle/>
        <a:p>
          <a:endParaRPr lang="zh-CN" altLang="en-US"/>
        </a:p>
      </dgm:t>
    </dgm:pt>
    <dgm:pt modelId="{1ED3EC1A-3433-4BCC-BB36-E0A21026A456}">
      <dgm:prSet/>
      <dgm:spPr/>
      <dgm:t>
        <a:bodyPr/>
        <a:lstStyle/>
        <a:p>
          <a:r>
            <a:rPr lang="en-US" altLang="zh-CN" b="1" dirty="0">
              <a:latin typeface="+mn-lt"/>
              <a:cs typeface="Times New Roman" panose="02020603050405020304" pitchFamily="18" charset="0"/>
            </a:rPr>
            <a:t>SUL</a:t>
          </a:r>
        </a:p>
        <a:p>
          <a:r>
            <a: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altLang="zh-CN" b="1" dirty="0">
              <a:latin typeface="+mn-lt"/>
              <a:cs typeface="Times New Roman" panose="02020603050405020304" pitchFamily="18" charset="0"/>
            </a:rPr>
            <a:t>model</a:t>
          </a:r>
          <a:endParaRPr lang="zh-CN" altLang="en-US" b="1" dirty="0">
            <a:latin typeface="+mn-lt"/>
            <a:cs typeface="Times New Roman" panose="02020603050405020304" pitchFamily="18" charset="0"/>
          </a:endParaRPr>
        </a:p>
      </dgm:t>
    </dgm:pt>
    <dgm:pt modelId="{D8F68739-5403-4C4A-8215-AC3264B9D579}" type="parTrans" cxnId="{443455B0-65A3-4DCC-B083-91709FFFD362}">
      <dgm:prSet/>
      <dgm:spPr/>
      <dgm:t>
        <a:bodyPr/>
        <a:lstStyle/>
        <a:p>
          <a:endParaRPr lang="zh-CN" altLang="en-US"/>
        </a:p>
      </dgm:t>
    </dgm:pt>
    <dgm:pt modelId="{DD590368-D31D-43EB-9AE9-6144ED9043F1}" type="sibTrans" cxnId="{443455B0-65A3-4DCC-B083-91709FFFD362}">
      <dgm:prSet/>
      <dgm:spPr/>
      <dgm:t>
        <a:bodyPr/>
        <a:lstStyle/>
        <a:p>
          <a:endParaRPr lang="zh-CN" altLang="en-US"/>
        </a:p>
      </dgm:t>
    </dgm:pt>
    <dgm:pt modelId="{75132A92-48D4-44E6-AF6F-2D16C08EECB2}" type="pres">
      <dgm:prSet presAssocID="{6158CBDB-000B-4FCA-A1BB-A34897A6BE93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94F99CAF-050E-4CC2-934E-323C3C548A2E}" type="pres">
      <dgm:prSet presAssocID="{9FFC6F56-5642-4BF1-BC1C-712E43F26656}" presName="hierRoot1" presStyleCnt="0"/>
      <dgm:spPr/>
    </dgm:pt>
    <dgm:pt modelId="{8533C07A-D872-463B-9A39-0A230C6E2398}" type="pres">
      <dgm:prSet presAssocID="{9FFC6F56-5642-4BF1-BC1C-712E43F26656}" presName="composite" presStyleCnt="0"/>
      <dgm:spPr/>
    </dgm:pt>
    <dgm:pt modelId="{42D3BF87-DF01-4A79-9921-325403C4EDC7}" type="pres">
      <dgm:prSet presAssocID="{9FFC6F56-5642-4BF1-BC1C-712E43F26656}" presName="background" presStyleLbl="node0" presStyleIdx="0" presStyleCnt="1"/>
      <dgm:spPr/>
    </dgm:pt>
    <dgm:pt modelId="{FA9F9C49-0C42-4CD9-B560-39F52E88ECC6}" type="pres">
      <dgm:prSet presAssocID="{9FFC6F56-5642-4BF1-BC1C-712E43F26656}" presName="text" presStyleLbl="fgAcc0" presStyleIdx="0" presStyleCnt="1">
        <dgm:presLayoutVars>
          <dgm:chPref val="3"/>
        </dgm:presLayoutVars>
      </dgm:prSet>
      <dgm:spPr/>
    </dgm:pt>
    <dgm:pt modelId="{763D6E02-6E80-4CB0-82EB-51D56598B857}" type="pres">
      <dgm:prSet presAssocID="{9FFC6F56-5642-4BF1-BC1C-712E43F26656}" presName="hierChild2" presStyleCnt="0"/>
      <dgm:spPr/>
    </dgm:pt>
    <dgm:pt modelId="{9C9D917F-E95A-4B6E-95D9-7DD95D4C26C4}" type="pres">
      <dgm:prSet presAssocID="{7F306F33-5B91-4FDD-BE71-B11DB476D685}" presName="Name10" presStyleLbl="parChTrans1D2" presStyleIdx="0" presStyleCnt="2"/>
      <dgm:spPr/>
    </dgm:pt>
    <dgm:pt modelId="{0E08F389-5BBE-487E-B31F-64AA73929900}" type="pres">
      <dgm:prSet presAssocID="{4A2E017A-87C5-4D13-B50F-2989CDDE7395}" presName="hierRoot2" presStyleCnt="0"/>
      <dgm:spPr/>
    </dgm:pt>
    <dgm:pt modelId="{A40ED488-0BC3-4271-BCA1-E374456810C8}" type="pres">
      <dgm:prSet presAssocID="{4A2E017A-87C5-4D13-B50F-2989CDDE7395}" presName="composite2" presStyleCnt="0"/>
      <dgm:spPr/>
    </dgm:pt>
    <dgm:pt modelId="{F49326BB-A7C3-41EF-9AFF-5F05BC420475}" type="pres">
      <dgm:prSet presAssocID="{4A2E017A-87C5-4D13-B50F-2989CDDE7395}" presName="background2" presStyleLbl="node2" presStyleIdx="0" presStyleCnt="2"/>
      <dgm:spPr/>
    </dgm:pt>
    <dgm:pt modelId="{D38C780A-3173-44F5-A44F-374F3DC26328}" type="pres">
      <dgm:prSet presAssocID="{4A2E017A-87C5-4D13-B50F-2989CDDE7395}" presName="text2" presStyleLbl="fgAcc2" presStyleIdx="0" presStyleCnt="2">
        <dgm:presLayoutVars>
          <dgm:chPref val="3"/>
        </dgm:presLayoutVars>
      </dgm:prSet>
      <dgm:spPr/>
    </dgm:pt>
    <dgm:pt modelId="{6F9F1104-7D8E-49F4-92CA-A1D5F3C99ABB}" type="pres">
      <dgm:prSet presAssocID="{4A2E017A-87C5-4D13-B50F-2989CDDE7395}" presName="hierChild3" presStyleCnt="0"/>
      <dgm:spPr/>
    </dgm:pt>
    <dgm:pt modelId="{9259ADFB-1220-4532-9F64-88C0DBF9084D}" type="pres">
      <dgm:prSet presAssocID="{0BE0BD1C-895E-4021-8E11-320E60600831}" presName="Name17" presStyleLbl="parChTrans1D3" presStyleIdx="0" presStyleCnt="4"/>
      <dgm:spPr/>
    </dgm:pt>
    <dgm:pt modelId="{25AA1E77-05F5-4F4A-BEDC-F4A2E5B05165}" type="pres">
      <dgm:prSet presAssocID="{1B95FC3D-EF4A-4B3B-A91C-1CD485F15347}" presName="hierRoot3" presStyleCnt="0"/>
      <dgm:spPr/>
    </dgm:pt>
    <dgm:pt modelId="{9F9ACA67-2547-4E62-8478-547D1437720E}" type="pres">
      <dgm:prSet presAssocID="{1B95FC3D-EF4A-4B3B-A91C-1CD485F15347}" presName="composite3" presStyleCnt="0"/>
      <dgm:spPr/>
    </dgm:pt>
    <dgm:pt modelId="{35395F41-5F2A-4E74-8699-21C5A4519B23}" type="pres">
      <dgm:prSet presAssocID="{1B95FC3D-EF4A-4B3B-A91C-1CD485F15347}" presName="background3" presStyleLbl="node3" presStyleIdx="0" presStyleCnt="4"/>
      <dgm:spPr/>
    </dgm:pt>
    <dgm:pt modelId="{443074BE-26B4-4ADC-97B1-34BC046B2CFB}" type="pres">
      <dgm:prSet presAssocID="{1B95FC3D-EF4A-4B3B-A91C-1CD485F15347}" presName="text3" presStyleLbl="fgAcc3" presStyleIdx="0" presStyleCnt="4">
        <dgm:presLayoutVars>
          <dgm:chPref val="3"/>
        </dgm:presLayoutVars>
      </dgm:prSet>
      <dgm:spPr/>
    </dgm:pt>
    <dgm:pt modelId="{87E2F0B6-649F-47C9-89A5-B79AB57A894C}" type="pres">
      <dgm:prSet presAssocID="{1B95FC3D-EF4A-4B3B-A91C-1CD485F15347}" presName="hierChild4" presStyleCnt="0"/>
      <dgm:spPr/>
    </dgm:pt>
    <dgm:pt modelId="{FBAD7D31-8723-4873-B2D4-318A604543CD}" type="pres">
      <dgm:prSet presAssocID="{D8F68739-5403-4C4A-8215-AC3264B9D579}" presName="Name17" presStyleLbl="parChTrans1D3" presStyleIdx="1" presStyleCnt="4"/>
      <dgm:spPr/>
    </dgm:pt>
    <dgm:pt modelId="{47266579-008C-47E0-BD41-22DA8FEA9039}" type="pres">
      <dgm:prSet presAssocID="{1ED3EC1A-3433-4BCC-BB36-E0A21026A456}" presName="hierRoot3" presStyleCnt="0"/>
      <dgm:spPr/>
    </dgm:pt>
    <dgm:pt modelId="{C576586A-3937-482F-96B4-8A2DAB14CF39}" type="pres">
      <dgm:prSet presAssocID="{1ED3EC1A-3433-4BCC-BB36-E0A21026A456}" presName="composite3" presStyleCnt="0"/>
      <dgm:spPr/>
    </dgm:pt>
    <dgm:pt modelId="{9FCFD946-4BCA-4E6F-9BCA-3F1A51800425}" type="pres">
      <dgm:prSet presAssocID="{1ED3EC1A-3433-4BCC-BB36-E0A21026A456}" presName="background3" presStyleLbl="node3" presStyleIdx="1" presStyleCnt="4"/>
      <dgm:spPr/>
    </dgm:pt>
    <dgm:pt modelId="{C0CF5837-63F2-40BE-8D06-788E5E6E3518}" type="pres">
      <dgm:prSet presAssocID="{1ED3EC1A-3433-4BCC-BB36-E0A21026A456}" presName="text3" presStyleLbl="fgAcc3" presStyleIdx="1" presStyleCnt="4">
        <dgm:presLayoutVars>
          <dgm:chPref val="3"/>
        </dgm:presLayoutVars>
      </dgm:prSet>
      <dgm:spPr/>
    </dgm:pt>
    <dgm:pt modelId="{9A41A4B2-FEA0-4D3E-BD04-4BE3F9CFC957}" type="pres">
      <dgm:prSet presAssocID="{1ED3EC1A-3433-4BCC-BB36-E0A21026A456}" presName="hierChild4" presStyleCnt="0"/>
      <dgm:spPr/>
    </dgm:pt>
    <dgm:pt modelId="{C2CA091D-4050-474F-9481-9F5DD06CCCF2}" type="pres">
      <dgm:prSet presAssocID="{BE9446E7-8EA6-498F-B7FC-9E254C9D2C2A}" presName="Name10" presStyleLbl="parChTrans1D2" presStyleIdx="1" presStyleCnt="2"/>
      <dgm:spPr/>
    </dgm:pt>
    <dgm:pt modelId="{A3BBE946-4295-4F9C-AB56-BEB46E9CE406}" type="pres">
      <dgm:prSet presAssocID="{642C1A4A-B21C-4241-970D-E3E47EAC3F27}" presName="hierRoot2" presStyleCnt="0"/>
      <dgm:spPr/>
    </dgm:pt>
    <dgm:pt modelId="{4FF85582-059D-42C3-A258-80B5249CE664}" type="pres">
      <dgm:prSet presAssocID="{642C1A4A-B21C-4241-970D-E3E47EAC3F27}" presName="composite2" presStyleCnt="0"/>
      <dgm:spPr/>
    </dgm:pt>
    <dgm:pt modelId="{6C684515-4B97-4084-BE3D-05A47E474813}" type="pres">
      <dgm:prSet presAssocID="{642C1A4A-B21C-4241-970D-E3E47EAC3F27}" presName="background2" presStyleLbl="node2" presStyleIdx="1" presStyleCnt="2"/>
      <dgm:spPr/>
    </dgm:pt>
    <dgm:pt modelId="{BA627587-A4F6-4022-AB11-8A47B4A414AD}" type="pres">
      <dgm:prSet presAssocID="{642C1A4A-B21C-4241-970D-E3E47EAC3F27}" presName="text2" presStyleLbl="fgAcc2" presStyleIdx="1" presStyleCnt="2">
        <dgm:presLayoutVars>
          <dgm:chPref val="3"/>
        </dgm:presLayoutVars>
      </dgm:prSet>
      <dgm:spPr/>
    </dgm:pt>
    <dgm:pt modelId="{7410EA19-BBD8-4B54-B588-1AE66C54934B}" type="pres">
      <dgm:prSet presAssocID="{642C1A4A-B21C-4241-970D-E3E47EAC3F27}" presName="hierChild3" presStyleCnt="0"/>
      <dgm:spPr/>
    </dgm:pt>
    <dgm:pt modelId="{FD738469-0F97-40C6-99B9-AEAFBE30F0B1}" type="pres">
      <dgm:prSet presAssocID="{1DB8DA31-7962-4B4F-9389-50C1F0A2BE55}" presName="Name17" presStyleLbl="parChTrans1D3" presStyleIdx="2" presStyleCnt="4"/>
      <dgm:spPr/>
    </dgm:pt>
    <dgm:pt modelId="{38C3A6C3-4D54-4721-97A7-F2FC7E1DADE5}" type="pres">
      <dgm:prSet presAssocID="{941B23FC-65D6-43E7-815E-B6EFC9019F80}" presName="hierRoot3" presStyleCnt="0"/>
      <dgm:spPr/>
    </dgm:pt>
    <dgm:pt modelId="{50626730-85B4-405D-817C-DA353E0310B4}" type="pres">
      <dgm:prSet presAssocID="{941B23FC-65D6-43E7-815E-B6EFC9019F80}" presName="composite3" presStyleCnt="0"/>
      <dgm:spPr/>
    </dgm:pt>
    <dgm:pt modelId="{C491A8D0-AC33-4AD4-9A35-F35FFE23BFF9}" type="pres">
      <dgm:prSet presAssocID="{941B23FC-65D6-43E7-815E-B6EFC9019F80}" presName="background3" presStyleLbl="node3" presStyleIdx="2" presStyleCnt="4"/>
      <dgm:spPr/>
    </dgm:pt>
    <dgm:pt modelId="{CEFB62EB-85B0-47FE-BB1C-7207EEEC9BD1}" type="pres">
      <dgm:prSet presAssocID="{941B23FC-65D6-43E7-815E-B6EFC9019F80}" presName="text3" presStyleLbl="fgAcc3" presStyleIdx="2" presStyleCnt="4">
        <dgm:presLayoutVars>
          <dgm:chPref val="3"/>
        </dgm:presLayoutVars>
      </dgm:prSet>
      <dgm:spPr/>
    </dgm:pt>
    <dgm:pt modelId="{B6D8BBF3-C51C-4D38-BB88-936FF8EE8675}" type="pres">
      <dgm:prSet presAssocID="{941B23FC-65D6-43E7-815E-B6EFC9019F80}" presName="hierChild4" presStyleCnt="0"/>
      <dgm:spPr/>
    </dgm:pt>
    <dgm:pt modelId="{4CB1ABB7-CD9C-4E85-AD5E-77E419815A16}" type="pres">
      <dgm:prSet presAssocID="{D313F3A2-A743-4936-A3C4-512C49AE7FA1}" presName="Name17" presStyleLbl="parChTrans1D3" presStyleIdx="3" presStyleCnt="4"/>
      <dgm:spPr/>
    </dgm:pt>
    <dgm:pt modelId="{F7AF3922-6059-40FB-897B-A83441C8ED0D}" type="pres">
      <dgm:prSet presAssocID="{6B2A2064-5895-4BC7-9FD1-09BA7134F550}" presName="hierRoot3" presStyleCnt="0"/>
      <dgm:spPr/>
    </dgm:pt>
    <dgm:pt modelId="{809AC3E8-A4A9-4DFA-9122-4CD78FE807A6}" type="pres">
      <dgm:prSet presAssocID="{6B2A2064-5895-4BC7-9FD1-09BA7134F550}" presName="composite3" presStyleCnt="0"/>
      <dgm:spPr/>
    </dgm:pt>
    <dgm:pt modelId="{C8846952-BB46-4C35-9037-81546866015C}" type="pres">
      <dgm:prSet presAssocID="{6B2A2064-5895-4BC7-9FD1-09BA7134F550}" presName="background3" presStyleLbl="node3" presStyleIdx="3" presStyleCnt="4"/>
      <dgm:spPr/>
    </dgm:pt>
    <dgm:pt modelId="{78F7FDB7-B91A-4676-8C2D-68771B586934}" type="pres">
      <dgm:prSet presAssocID="{6B2A2064-5895-4BC7-9FD1-09BA7134F550}" presName="text3" presStyleLbl="fgAcc3" presStyleIdx="3" presStyleCnt="4">
        <dgm:presLayoutVars>
          <dgm:chPref val="3"/>
        </dgm:presLayoutVars>
      </dgm:prSet>
      <dgm:spPr/>
    </dgm:pt>
    <dgm:pt modelId="{BB760806-389D-4CD7-8EC3-1BC05523DD75}" type="pres">
      <dgm:prSet presAssocID="{6B2A2064-5895-4BC7-9FD1-09BA7134F550}" presName="hierChild4" presStyleCnt="0"/>
      <dgm:spPr/>
    </dgm:pt>
  </dgm:ptLst>
  <dgm:cxnLst>
    <dgm:cxn modelId="{4AD81203-3313-4469-9904-5AED5D80406E}" type="presOf" srcId="{642C1A4A-B21C-4241-970D-E3E47EAC3F27}" destId="{BA627587-A4F6-4022-AB11-8A47B4A414AD}" srcOrd="0" destOrd="0" presId="urn:microsoft.com/office/officeart/2005/8/layout/hierarchy1"/>
    <dgm:cxn modelId="{72C1640F-8F14-451B-86E5-232E087BD0FA}" type="presOf" srcId="{D313F3A2-A743-4936-A3C4-512C49AE7FA1}" destId="{4CB1ABB7-CD9C-4E85-AD5E-77E419815A16}" srcOrd="0" destOrd="0" presId="urn:microsoft.com/office/officeart/2005/8/layout/hierarchy1"/>
    <dgm:cxn modelId="{9B78BF0F-8875-41F6-8431-C7AD3677733E}" srcId="{642C1A4A-B21C-4241-970D-E3E47EAC3F27}" destId="{6B2A2064-5895-4BC7-9FD1-09BA7134F550}" srcOrd="1" destOrd="0" parTransId="{D313F3A2-A743-4936-A3C4-512C49AE7FA1}" sibTransId="{944813D9-F30C-4F71-9B1A-13F64439AB32}"/>
    <dgm:cxn modelId="{81D66B1F-42A1-4911-8680-CBAB3E044D67}" type="presOf" srcId="{1B95FC3D-EF4A-4B3B-A91C-1CD485F15347}" destId="{443074BE-26B4-4ADC-97B1-34BC046B2CFB}" srcOrd="0" destOrd="0" presId="urn:microsoft.com/office/officeart/2005/8/layout/hierarchy1"/>
    <dgm:cxn modelId="{1CCBA726-C58C-4148-974C-3AD1EEBE8439}" type="presOf" srcId="{941B23FC-65D6-43E7-815E-B6EFC9019F80}" destId="{CEFB62EB-85B0-47FE-BB1C-7207EEEC9BD1}" srcOrd="0" destOrd="0" presId="urn:microsoft.com/office/officeart/2005/8/layout/hierarchy1"/>
    <dgm:cxn modelId="{2331FC2D-D102-4ED5-BF07-0F356CE1DC88}" type="presOf" srcId="{1DB8DA31-7962-4B4F-9389-50C1F0A2BE55}" destId="{FD738469-0F97-40C6-99B9-AEAFBE30F0B1}" srcOrd="0" destOrd="0" presId="urn:microsoft.com/office/officeart/2005/8/layout/hierarchy1"/>
    <dgm:cxn modelId="{48CE8E5C-C7D2-4987-A2AB-678B3756860D}" type="presOf" srcId="{D8F68739-5403-4C4A-8215-AC3264B9D579}" destId="{FBAD7D31-8723-4873-B2D4-318A604543CD}" srcOrd="0" destOrd="0" presId="urn:microsoft.com/office/officeart/2005/8/layout/hierarchy1"/>
    <dgm:cxn modelId="{66CB7447-AE29-4519-BE72-104D73575B0F}" type="presOf" srcId="{6158CBDB-000B-4FCA-A1BB-A34897A6BE93}" destId="{75132A92-48D4-44E6-AF6F-2D16C08EECB2}" srcOrd="0" destOrd="0" presId="urn:microsoft.com/office/officeart/2005/8/layout/hierarchy1"/>
    <dgm:cxn modelId="{2D3EF658-D323-4129-BBA0-32ACAD0C776C}" srcId="{9FFC6F56-5642-4BF1-BC1C-712E43F26656}" destId="{4A2E017A-87C5-4D13-B50F-2989CDDE7395}" srcOrd="0" destOrd="0" parTransId="{7F306F33-5B91-4FDD-BE71-B11DB476D685}" sibTransId="{B6988033-822C-4B39-859D-6E5FD30A88F5}"/>
    <dgm:cxn modelId="{1EB0757F-F1C1-4A18-B1F7-23D881306555}" type="presOf" srcId="{0BE0BD1C-895E-4021-8E11-320E60600831}" destId="{9259ADFB-1220-4532-9F64-88C0DBF9084D}" srcOrd="0" destOrd="0" presId="urn:microsoft.com/office/officeart/2005/8/layout/hierarchy1"/>
    <dgm:cxn modelId="{0897F27F-4B56-4332-B4AB-247D6FC34FBD}" type="presOf" srcId="{4A2E017A-87C5-4D13-B50F-2989CDDE7395}" destId="{D38C780A-3173-44F5-A44F-374F3DC26328}" srcOrd="0" destOrd="0" presId="urn:microsoft.com/office/officeart/2005/8/layout/hierarchy1"/>
    <dgm:cxn modelId="{575C2786-742F-411C-9E75-F577ED39F809}" type="presOf" srcId="{6B2A2064-5895-4BC7-9FD1-09BA7134F550}" destId="{78F7FDB7-B91A-4676-8C2D-68771B586934}" srcOrd="0" destOrd="0" presId="urn:microsoft.com/office/officeart/2005/8/layout/hierarchy1"/>
    <dgm:cxn modelId="{F3B93894-86D9-4138-8823-FD27B99F7B14}" type="presOf" srcId="{1ED3EC1A-3433-4BCC-BB36-E0A21026A456}" destId="{C0CF5837-63F2-40BE-8D06-788E5E6E3518}" srcOrd="0" destOrd="0" presId="urn:microsoft.com/office/officeart/2005/8/layout/hierarchy1"/>
    <dgm:cxn modelId="{F8BF0E9A-32D3-4CDA-B815-1F7B744F9806}" type="presOf" srcId="{7F306F33-5B91-4FDD-BE71-B11DB476D685}" destId="{9C9D917F-E95A-4B6E-95D9-7DD95D4C26C4}" srcOrd="0" destOrd="0" presId="urn:microsoft.com/office/officeart/2005/8/layout/hierarchy1"/>
    <dgm:cxn modelId="{E32F9B9D-506D-4943-8DBA-EE8AA09A056C}" srcId="{4A2E017A-87C5-4D13-B50F-2989CDDE7395}" destId="{1B95FC3D-EF4A-4B3B-A91C-1CD485F15347}" srcOrd="0" destOrd="0" parTransId="{0BE0BD1C-895E-4021-8E11-320E60600831}" sibTransId="{6356A353-3EB8-4F1E-A24E-A26AEEFD1C77}"/>
    <dgm:cxn modelId="{D46BFDAB-0D4C-4812-9E32-2E606D748D4D}" type="presOf" srcId="{9FFC6F56-5642-4BF1-BC1C-712E43F26656}" destId="{FA9F9C49-0C42-4CD9-B560-39F52E88ECC6}" srcOrd="0" destOrd="0" presId="urn:microsoft.com/office/officeart/2005/8/layout/hierarchy1"/>
    <dgm:cxn modelId="{1F5D49AE-A681-4586-9885-46E4B103C947}" type="presOf" srcId="{BE9446E7-8EA6-498F-B7FC-9E254C9D2C2A}" destId="{C2CA091D-4050-474F-9481-9F5DD06CCCF2}" srcOrd="0" destOrd="0" presId="urn:microsoft.com/office/officeart/2005/8/layout/hierarchy1"/>
    <dgm:cxn modelId="{443455B0-65A3-4DCC-B083-91709FFFD362}" srcId="{4A2E017A-87C5-4D13-B50F-2989CDDE7395}" destId="{1ED3EC1A-3433-4BCC-BB36-E0A21026A456}" srcOrd="1" destOrd="0" parTransId="{D8F68739-5403-4C4A-8215-AC3264B9D579}" sibTransId="{DD590368-D31D-43EB-9AE9-6144ED9043F1}"/>
    <dgm:cxn modelId="{3E73D0E6-E395-4B9E-BFDA-36F6F666C220}" srcId="{9FFC6F56-5642-4BF1-BC1C-712E43F26656}" destId="{642C1A4A-B21C-4241-970D-E3E47EAC3F27}" srcOrd="1" destOrd="0" parTransId="{BE9446E7-8EA6-498F-B7FC-9E254C9D2C2A}" sibTransId="{80138097-0E8D-4705-8B3F-D45331128EAD}"/>
    <dgm:cxn modelId="{8C8488E8-C1D7-41DF-AD14-E93F8A559DA5}" srcId="{642C1A4A-B21C-4241-970D-E3E47EAC3F27}" destId="{941B23FC-65D6-43E7-815E-B6EFC9019F80}" srcOrd="0" destOrd="0" parTransId="{1DB8DA31-7962-4B4F-9389-50C1F0A2BE55}" sibTransId="{21A89706-7190-4610-B9DF-059358B159B8}"/>
    <dgm:cxn modelId="{F9D5F9EE-6E4C-43A4-88A9-990E7E75EFFB}" srcId="{6158CBDB-000B-4FCA-A1BB-A34897A6BE93}" destId="{9FFC6F56-5642-4BF1-BC1C-712E43F26656}" srcOrd="0" destOrd="0" parTransId="{ECD89EAE-0789-4D74-8B1E-03CF37751A33}" sibTransId="{9BD69410-8420-4834-9868-8C560D4C7704}"/>
    <dgm:cxn modelId="{B0E09E52-12AE-44E8-BAAE-44FA0E4A98B1}" type="presParOf" srcId="{75132A92-48D4-44E6-AF6F-2D16C08EECB2}" destId="{94F99CAF-050E-4CC2-934E-323C3C548A2E}" srcOrd="0" destOrd="0" presId="urn:microsoft.com/office/officeart/2005/8/layout/hierarchy1"/>
    <dgm:cxn modelId="{1B73ABA3-465B-4444-A0F8-9ADF9812CB3E}" type="presParOf" srcId="{94F99CAF-050E-4CC2-934E-323C3C548A2E}" destId="{8533C07A-D872-463B-9A39-0A230C6E2398}" srcOrd="0" destOrd="0" presId="urn:microsoft.com/office/officeart/2005/8/layout/hierarchy1"/>
    <dgm:cxn modelId="{25DF6BB5-5B1E-4BDB-B1EB-185B5A56D062}" type="presParOf" srcId="{8533C07A-D872-463B-9A39-0A230C6E2398}" destId="{42D3BF87-DF01-4A79-9921-325403C4EDC7}" srcOrd="0" destOrd="0" presId="urn:microsoft.com/office/officeart/2005/8/layout/hierarchy1"/>
    <dgm:cxn modelId="{4810D7B3-285B-4D53-A3F8-0E7A0FBAFBFC}" type="presParOf" srcId="{8533C07A-D872-463B-9A39-0A230C6E2398}" destId="{FA9F9C49-0C42-4CD9-B560-39F52E88ECC6}" srcOrd="1" destOrd="0" presId="urn:microsoft.com/office/officeart/2005/8/layout/hierarchy1"/>
    <dgm:cxn modelId="{56DCD30A-2F6C-4693-AED9-ADB01B102958}" type="presParOf" srcId="{94F99CAF-050E-4CC2-934E-323C3C548A2E}" destId="{763D6E02-6E80-4CB0-82EB-51D56598B857}" srcOrd="1" destOrd="0" presId="urn:microsoft.com/office/officeart/2005/8/layout/hierarchy1"/>
    <dgm:cxn modelId="{45FB8905-EF51-4413-9700-C0F1BA9EBEB7}" type="presParOf" srcId="{763D6E02-6E80-4CB0-82EB-51D56598B857}" destId="{9C9D917F-E95A-4B6E-95D9-7DD95D4C26C4}" srcOrd="0" destOrd="0" presId="urn:microsoft.com/office/officeart/2005/8/layout/hierarchy1"/>
    <dgm:cxn modelId="{D2BF7094-34E9-4E81-A9E1-DBBC6F8201E6}" type="presParOf" srcId="{763D6E02-6E80-4CB0-82EB-51D56598B857}" destId="{0E08F389-5BBE-487E-B31F-64AA73929900}" srcOrd="1" destOrd="0" presId="urn:microsoft.com/office/officeart/2005/8/layout/hierarchy1"/>
    <dgm:cxn modelId="{15C4E271-A289-4206-A490-A92D5B476901}" type="presParOf" srcId="{0E08F389-5BBE-487E-B31F-64AA73929900}" destId="{A40ED488-0BC3-4271-BCA1-E374456810C8}" srcOrd="0" destOrd="0" presId="urn:microsoft.com/office/officeart/2005/8/layout/hierarchy1"/>
    <dgm:cxn modelId="{23B3837B-DDA2-4C93-AD45-7385515CBBFE}" type="presParOf" srcId="{A40ED488-0BC3-4271-BCA1-E374456810C8}" destId="{F49326BB-A7C3-41EF-9AFF-5F05BC420475}" srcOrd="0" destOrd="0" presId="urn:microsoft.com/office/officeart/2005/8/layout/hierarchy1"/>
    <dgm:cxn modelId="{77E6B39F-7691-4828-BC53-F7AF5C537EC5}" type="presParOf" srcId="{A40ED488-0BC3-4271-BCA1-E374456810C8}" destId="{D38C780A-3173-44F5-A44F-374F3DC26328}" srcOrd="1" destOrd="0" presId="urn:microsoft.com/office/officeart/2005/8/layout/hierarchy1"/>
    <dgm:cxn modelId="{AC461E8E-A0FD-41A6-898D-D36BD1A1F836}" type="presParOf" srcId="{0E08F389-5BBE-487E-B31F-64AA73929900}" destId="{6F9F1104-7D8E-49F4-92CA-A1D5F3C99ABB}" srcOrd="1" destOrd="0" presId="urn:microsoft.com/office/officeart/2005/8/layout/hierarchy1"/>
    <dgm:cxn modelId="{CF927B06-A033-464B-A620-A6A9E9AE3D21}" type="presParOf" srcId="{6F9F1104-7D8E-49F4-92CA-A1D5F3C99ABB}" destId="{9259ADFB-1220-4532-9F64-88C0DBF9084D}" srcOrd="0" destOrd="0" presId="urn:microsoft.com/office/officeart/2005/8/layout/hierarchy1"/>
    <dgm:cxn modelId="{5661C8DF-E7A7-4EB1-833E-6BE68B90898D}" type="presParOf" srcId="{6F9F1104-7D8E-49F4-92CA-A1D5F3C99ABB}" destId="{25AA1E77-05F5-4F4A-BEDC-F4A2E5B05165}" srcOrd="1" destOrd="0" presId="urn:microsoft.com/office/officeart/2005/8/layout/hierarchy1"/>
    <dgm:cxn modelId="{24027891-F4F4-432E-AF81-440CB092813C}" type="presParOf" srcId="{25AA1E77-05F5-4F4A-BEDC-F4A2E5B05165}" destId="{9F9ACA67-2547-4E62-8478-547D1437720E}" srcOrd="0" destOrd="0" presId="urn:microsoft.com/office/officeart/2005/8/layout/hierarchy1"/>
    <dgm:cxn modelId="{68A34BFE-6E31-4036-A97A-A7BF0B6EBC0F}" type="presParOf" srcId="{9F9ACA67-2547-4E62-8478-547D1437720E}" destId="{35395F41-5F2A-4E74-8699-21C5A4519B23}" srcOrd="0" destOrd="0" presId="urn:microsoft.com/office/officeart/2005/8/layout/hierarchy1"/>
    <dgm:cxn modelId="{35975731-DA2D-40EF-A20F-AE327EDF906C}" type="presParOf" srcId="{9F9ACA67-2547-4E62-8478-547D1437720E}" destId="{443074BE-26B4-4ADC-97B1-34BC046B2CFB}" srcOrd="1" destOrd="0" presId="urn:microsoft.com/office/officeart/2005/8/layout/hierarchy1"/>
    <dgm:cxn modelId="{DC30B73E-667C-49FC-B785-7B7D3036A843}" type="presParOf" srcId="{25AA1E77-05F5-4F4A-BEDC-F4A2E5B05165}" destId="{87E2F0B6-649F-47C9-89A5-B79AB57A894C}" srcOrd="1" destOrd="0" presId="urn:microsoft.com/office/officeart/2005/8/layout/hierarchy1"/>
    <dgm:cxn modelId="{803FCBD7-3A49-4D4E-B24F-74776BC62E5C}" type="presParOf" srcId="{6F9F1104-7D8E-49F4-92CA-A1D5F3C99ABB}" destId="{FBAD7D31-8723-4873-B2D4-318A604543CD}" srcOrd="2" destOrd="0" presId="urn:microsoft.com/office/officeart/2005/8/layout/hierarchy1"/>
    <dgm:cxn modelId="{1C8E0468-D880-4E18-ACAA-0FED78603EC4}" type="presParOf" srcId="{6F9F1104-7D8E-49F4-92CA-A1D5F3C99ABB}" destId="{47266579-008C-47E0-BD41-22DA8FEA9039}" srcOrd="3" destOrd="0" presId="urn:microsoft.com/office/officeart/2005/8/layout/hierarchy1"/>
    <dgm:cxn modelId="{2F272E14-F0EC-4BC5-82A1-B5430D8EF178}" type="presParOf" srcId="{47266579-008C-47E0-BD41-22DA8FEA9039}" destId="{C576586A-3937-482F-96B4-8A2DAB14CF39}" srcOrd="0" destOrd="0" presId="urn:microsoft.com/office/officeart/2005/8/layout/hierarchy1"/>
    <dgm:cxn modelId="{60967F75-CDA5-440F-AA8B-1363646A2DDD}" type="presParOf" srcId="{C576586A-3937-482F-96B4-8A2DAB14CF39}" destId="{9FCFD946-4BCA-4E6F-9BCA-3F1A51800425}" srcOrd="0" destOrd="0" presId="urn:microsoft.com/office/officeart/2005/8/layout/hierarchy1"/>
    <dgm:cxn modelId="{47F28295-B084-4FED-B37C-131FBCBEE339}" type="presParOf" srcId="{C576586A-3937-482F-96B4-8A2DAB14CF39}" destId="{C0CF5837-63F2-40BE-8D06-788E5E6E3518}" srcOrd="1" destOrd="0" presId="urn:microsoft.com/office/officeart/2005/8/layout/hierarchy1"/>
    <dgm:cxn modelId="{BA5651D8-9351-45D3-91C4-DCCF3E55ECCE}" type="presParOf" srcId="{47266579-008C-47E0-BD41-22DA8FEA9039}" destId="{9A41A4B2-FEA0-4D3E-BD04-4BE3F9CFC957}" srcOrd="1" destOrd="0" presId="urn:microsoft.com/office/officeart/2005/8/layout/hierarchy1"/>
    <dgm:cxn modelId="{165859F2-5870-4965-842D-FAB2F7AC413A}" type="presParOf" srcId="{763D6E02-6E80-4CB0-82EB-51D56598B857}" destId="{C2CA091D-4050-474F-9481-9F5DD06CCCF2}" srcOrd="2" destOrd="0" presId="urn:microsoft.com/office/officeart/2005/8/layout/hierarchy1"/>
    <dgm:cxn modelId="{BF4A2DD8-D1FE-4C45-862A-D015801B0D1F}" type="presParOf" srcId="{763D6E02-6E80-4CB0-82EB-51D56598B857}" destId="{A3BBE946-4295-4F9C-AB56-BEB46E9CE406}" srcOrd="3" destOrd="0" presId="urn:microsoft.com/office/officeart/2005/8/layout/hierarchy1"/>
    <dgm:cxn modelId="{AA3E1D79-B090-4CEF-841C-6DFB0987814C}" type="presParOf" srcId="{A3BBE946-4295-4F9C-AB56-BEB46E9CE406}" destId="{4FF85582-059D-42C3-A258-80B5249CE664}" srcOrd="0" destOrd="0" presId="urn:microsoft.com/office/officeart/2005/8/layout/hierarchy1"/>
    <dgm:cxn modelId="{22E43F1D-98B9-4685-B52B-EDB7381B5F8B}" type="presParOf" srcId="{4FF85582-059D-42C3-A258-80B5249CE664}" destId="{6C684515-4B97-4084-BE3D-05A47E474813}" srcOrd="0" destOrd="0" presId="urn:microsoft.com/office/officeart/2005/8/layout/hierarchy1"/>
    <dgm:cxn modelId="{DCF7FE2A-0436-4F24-91FE-FF0B66939BE4}" type="presParOf" srcId="{4FF85582-059D-42C3-A258-80B5249CE664}" destId="{BA627587-A4F6-4022-AB11-8A47B4A414AD}" srcOrd="1" destOrd="0" presId="urn:microsoft.com/office/officeart/2005/8/layout/hierarchy1"/>
    <dgm:cxn modelId="{B531FA4D-4063-44DA-B171-938AA8D34BBF}" type="presParOf" srcId="{A3BBE946-4295-4F9C-AB56-BEB46E9CE406}" destId="{7410EA19-BBD8-4B54-B588-1AE66C54934B}" srcOrd="1" destOrd="0" presId="urn:microsoft.com/office/officeart/2005/8/layout/hierarchy1"/>
    <dgm:cxn modelId="{5AC221AE-587C-4795-9A76-B89B03852991}" type="presParOf" srcId="{7410EA19-BBD8-4B54-B588-1AE66C54934B}" destId="{FD738469-0F97-40C6-99B9-AEAFBE30F0B1}" srcOrd="0" destOrd="0" presId="urn:microsoft.com/office/officeart/2005/8/layout/hierarchy1"/>
    <dgm:cxn modelId="{CF867480-9079-4202-850C-65045E3BBC07}" type="presParOf" srcId="{7410EA19-BBD8-4B54-B588-1AE66C54934B}" destId="{38C3A6C3-4D54-4721-97A7-F2FC7E1DADE5}" srcOrd="1" destOrd="0" presId="urn:microsoft.com/office/officeart/2005/8/layout/hierarchy1"/>
    <dgm:cxn modelId="{2E3AAE87-A153-4C68-83BB-DB3D3AF0310D}" type="presParOf" srcId="{38C3A6C3-4D54-4721-97A7-F2FC7E1DADE5}" destId="{50626730-85B4-405D-817C-DA353E0310B4}" srcOrd="0" destOrd="0" presId="urn:microsoft.com/office/officeart/2005/8/layout/hierarchy1"/>
    <dgm:cxn modelId="{F407E19A-DABB-4EEA-90E9-B240F7911A52}" type="presParOf" srcId="{50626730-85B4-405D-817C-DA353E0310B4}" destId="{C491A8D0-AC33-4AD4-9A35-F35FFE23BFF9}" srcOrd="0" destOrd="0" presId="urn:microsoft.com/office/officeart/2005/8/layout/hierarchy1"/>
    <dgm:cxn modelId="{D179CFD0-5A41-4B4B-A82E-E0A7FA892990}" type="presParOf" srcId="{50626730-85B4-405D-817C-DA353E0310B4}" destId="{CEFB62EB-85B0-47FE-BB1C-7207EEEC9BD1}" srcOrd="1" destOrd="0" presId="urn:microsoft.com/office/officeart/2005/8/layout/hierarchy1"/>
    <dgm:cxn modelId="{F2271467-152E-4893-8B92-6CE2C94659AA}" type="presParOf" srcId="{38C3A6C3-4D54-4721-97A7-F2FC7E1DADE5}" destId="{B6D8BBF3-C51C-4D38-BB88-936FF8EE8675}" srcOrd="1" destOrd="0" presId="urn:microsoft.com/office/officeart/2005/8/layout/hierarchy1"/>
    <dgm:cxn modelId="{CC6CC627-CD20-4CBE-A4FB-904A5D9BFCEA}" type="presParOf" srcId="{7410EA19-BBD8-4B54-B588-1AE66C54934B}" destId="{4CB1ABB7-CD9C-4E85-AD5E-77E419815A16}" srcOrd="2" destOrd="0" presId="urn:microsoft.com/office/officeart/2005/8/layout/hierarchy1"/>
    <dgm:cxn modelId="{316E830C-D1A5-4F71-97DC-0F73C18AFDA9}" type="presParOf" srcId="{7410EA19-BBD8-4B54-B588-1AE66C54934B}" destId="{F7AF3922-6059-40FB-897B-A83441C8ED0D}" srcOrd="3" destOrd="0" presId="urn:microsoft.com/office/officeart/2005/8/layout/hierarchy1"/>
    <dgm:cxn modelId="{9941CFCA-9EAD-4A7D-A945-686C5E9F176F}" type="presParOf" srcId="{F7AF3922-6059-40FB-897B-A83441C8ED0D}" destId="{809AC3E8-A4A9-4DFA-9122-4CD78FE807A6}" srcOrd="0" destOrd="0" presId="urn:microsoft.com/office/officeart/2005/8/layout/hierarchy1"/>
    <dgm:cxn modelId="{A58DF60B-6F88-414C-A63A-6C89EEDD79B8}" type="presParOf" srcId="{809AC3E8-A4A9-4DFA-9122-4CD78FE807A6}" destId="{C8846952-BB46-4C35-9037-81546866015C}" srcOrd="0" destOrd="0" presId="urn:microsoft.com/office/officeart/2005/8/layout/hierarchy1"/>
    <dgm:cxn modelId="{8BF40CFC-06EE-41F0-A058-ED25D2EB6AD3}" type="presParOf" srcId="{809AC3E8-A4A9-4DFA-9122-4CD78FE807A6}" destId="{78F7FDB7-B91A-4676-8C2D-68771B586934}" srcOrd="1" destOrd="0" presId="urn:microsoft.com/office/officeart/2005/8/layout/hierarchy1"/>
    <dgm:cxn modelId="{A61DFE2D-9ED6-4A11-9381-8240F50B19B0}" type="presParOf" srcId="{F7AF3922-6059-40FB-897B-A83441C8ED0D}" destId="{BB760806-389D-4CD7-8EC3-1BC05523DD75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  <a:ext uri="{C62137D5-CB1D-491B-B009-E17868A290BF}">
      <dgm14:recolorImg xmlns:dgm14="http://schemas.microsoft.com/office/drawing/2010/diagram" val="1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273C796C-F60C-4612-A905-69E9A38BA7DE}" type="doc">
      <dgm:prSet loTypeId="urn:microsoft.com/office/officeart/2005/8/layout/process1" loCatId="process" qsTypeId="urn:microsoft.com/office/officeart/2005/8/quickstyle/3d7" qsCatId="3D" csTypeId="urn:microsoft.com/office/officeart/2005/8/colors/accent1_2" csCatId="accent1" phldr="1"/>
      <dgm:spPr/>
      <dgm:t>
        <a:bodyPr/>
        <a:lstStyle/>
        <a:p>
          <a:endParaRPr lang="zh-CN" altLang="en-US"/>
        </a:p>
      </dgm:t>
    </dgm:pt>
    <dgm:pt modelId="{15BAF81E-FF00-4D00-A31A-241C9258927B}">
      <dgm:prSet phldrT="[文本]" custT="1"/>
      <dgm:spPr/>
      <dgm:t>
        <a:bodyPr/>
        <a:lstStyle/>
        <a:p>
          <a:r>
            <a:rPr lang="en-US" altLang="zh-CN" sz="1200" b="1" dirty="0"/>
            <a:t>SUL</a:t>
          </a:r>
        </a:p>
        <a:p>
          <a:r>
            <a:rPr lang="en-US" altLang="zh-CN" sz="1200" b="1" dirty="0"/>
            <a:t> model</a:t>
          </a:r>
          <a:endParaRPr lang="zh-CN" altLang="en-US" sz="1200" b="1" dirty="0"/>
        </a:p>
      </dgm:t>
    </dgm:pt>
    <dgm:pt modelId="{68B0356E-8763-403F-AE3D-9AECC6FD9AF4}" type="parTrans" cxnId="{C74166A8-2898-4513-AB59-46C35EDEBA77}">
      <dgm:prSet/>
      <dgm:spPr/>
      <dgm:t>
        <a:bodyPr/>
        <a:lstStyle/>
        <a:p>
          <a:endParaRPr lang="zh-CN" altLang="en-US"/>
        </a:p>
      </dgm:t>
    </dgm:pt>
    <dgm:pt modelId="{4965A01C-DCEC-4A39-B713-7664AC80FFEC}" type="sibTrans" cxnId="{C74166A8-2898-4513-AB59-46C35EDEBA77}">
      <dgm:prSet/>
      <dgm:spPr/>
      <dgm:t>
        <a:bodyPr/>
        <a:lstStyle/>
        <a:p>
          <a:endParaRPr lang="zh-CN" altLang="en-US"/>
        </a:p>
      </dgm:t>
    </dgm:pt>
    <dgm:pt modelId="{DA51ECC6-3464-4EFB-8D4E-48E9E94BF27A}">
      <dgm:prSet phldrT="[文本]" custT="1"/>
      <dgm:spPr/>
      <dgm:t>
        <a:bodyPr/>
        <a:lstStyle/>
        <a:p>
          <a:r>
            <a:rPr lang="en-US" altLang="zh-CN" sz="1200" b="1" dirty="0"/>
            <a:t>PET/CT </a:t>
          </a:r>
        </a:p>
        <a:p>
          <a:r>
            <a:rPr lang="en-US" altLang="zh-CN" sz="1200" b="1" dirty="0"/>
            <a:t>model</a:t>
          </a:r>
          <a:endParaRPr lang="zh-CN" altLang="en-US" sz="1200" b="1" dirty="0"/>
        </a:p>
      </dgm:t>
    </dgm:pt>
    <dgm:pt modelId="{56FF7315-E00E-4389-A0BD-C8085A4A4BFB}" type="parTrans" cxnId="{3B584F26-7151-4ACE-A2FF-C77A0A17B319}">
      <dgm:prSet/>
      <dgm:spPr/>
      <dgm:t>
        <a:bodyPr/>
        <a:lstStyle/>
        <a:p>
          <a:endParaRPr lang="zh-CN" altLang="en-US"/>
        </a:p>
      </dgm:t>
    </dgm:pt>
    <dgm:pt modelId="{2521A64C-343E-40D2-B755-9CD9CADC1D90}" type="sibTrans" cxnId="{3B584F26-7151-4ACE-A2FF-C77A0A17B319}">
      <dgm:prSet/>
      <dgm:spPr/>
      <dgm:t>
        <a:bodyPr/>
        <a:lstStyle/>
        <a:p>
          <a:endParaRPr lang="zh-CN" altLang="en-US"/>
        </a:p>
      </dgm:t>
    </dgm:pt>
    <dgm:pt modelId="{AD1B97EC-4724-42B9-9E11-DFD83D79179B}" type="pres">
      <dgm:prSet presAssocID="{273C796C-F60C-4612-A905-69E9A38BA7DE}" presName="Name0" presStyleCnt="0">
        <dgm:presLayoutVars>
          <dgm:dir/>
          <dgm:resizeHandles val="exact"/>
        </dgm:presLayoutVars>
      </dgm:prSet>
      <dgm:spPr/>
    </dgm:pt>
    <dgm:pt modelId="{51D3FD1A-0D1F-4D91-B9A9-2E605C9ABB1A}" type="pres">
      <dgm:prSet presAssocID="{15BAF81E-FF00-4D00-A31A-241C9258927B}" presName="node" presStyleLbl="node1" presStyleIdx="0" presStyleCnt="2">
        <dgm:presLayoutVars>
          <dgm:bulletEnabled val="1"/>
        </dgm:presLayoutVars>
      </dgm:prSet>
      <dgm:spPr/>
    </dgm:pt>
    <dgm:pt modelId="{43F1A160-6D85-4079-BF83-2661387C6E2D}" type="pres">
      <dgm:prSet presAssocID="{4965A01C-DCEC-4A39-B713-7664AC80FFEC}" presName="sibTrans" presStyleLbl="sibTrans2D1" presStyleIdx="0" presStyleCnt="1"/>
      <dgm:spPr/>
    </dgm:pt>
    <dgm:pt modelId="{7097948E-38D9-4C81-87C0-5C8163A149E2}" type="pres">
      <dgm:prSet presAssocID="{4965A01C-DCEC-4A39-B713-7664AC80FFEC}" presName="connectorText" presStyleLbl="sibTrans2D1" presStyleIdx="0" presStyleCnt="1"/>
      <dgm:spPr/>
    </dgm:pt>
    <dgm:pt modelId="{FBE4BAEC-5EF1-45FC-844B-8B2D4B477F74}" type="pres">
      <dgm:prSet presAssocID="{DA51ECC6-3464-4EFB-8D4E-48E9E94BF27A}" presName="node" presStyleLbl="node1" presStyleIdx="1" presStyleCnt="2">
        <dgm:presLayoutVars>
          <dgm:bulletEnabled val="1"/>
        </dgm:presLayoutVars>
      </dgm:prSet>
      <dgm:spPr/>
    </dgm:pt>
  </dgm:ptLst>
  <dgm:cxnLst>
    <dgm:cxn modelId="{AA29A604-655F-4478-9020-B74749465262}" type="presOf" srcId="{4965A01C-DCEC-4A39-B713-7664AC80FFEC}" destId="{7097948E-38D9-4C81-87C0-5C8163A149E2}" srcOrd="1" destOrd="0" presId="urn:microsoft.com/office/officeart/2005/8/layout/process1"/>
    <dgm:cxn modelId="{3B584F26-7151-4ACE-A2FF-C77A0A17B319}" srcId="{273C796C-F60C-4612-A905-69E9A38BA7DE}" destId="{DA51ECC6-3464-4EFB-8D4E-48E9E94BF27A}" srcOrd="1" destOrd="0" parTransId="{56FF7315-E00E-4389-A0BD-C8085A4A4BFB}" sibTransId="{2521A64C-343E-40D2-B755-9CD9CADC1D90}"/>
    <dgm:cxn modelId="{D0C4562E-2848-4B73-8FF1-241CFC6C174A}" type="presOf" srcId="{DA51ECC6-3464-4EFB-8D4E-48E9E94BF27A}" destId="{FBE4BAEC-5EF1-45FC-844B-8B2D4B477F74}" srcOrd="0" destOrd="0" presId="urn:microsoft.com/office/officeart/2005/8/layout/process1"/>
    <dgm:cxn modelId="{E7DE798A-F397-48A6-B27B-3F86E89E683E}" type="presOf" srcId="{273C796C-F60C-4612-A905-69E9A38BA7DE}" destId="{AD1B97EC-4724-42B9-9E11-DFD83D79179B}" srcOrd="0" destOrd="0" presId="urn:microsoft.com/office/officeart/2005/8/layout/process1"/>
    <dgm:cxn modelId="{C74166A8-2898-4513-AB59-46C35EDEBA77}" srcId="{273C796C-F60C-4612-A905-69E9A38BA7DE}" destId="{15BAF81E-FF00-4D00-A31A-241C9258927B}" srcOrd="0" destOrd="0" parTransId="{68B0356E-8763-403F-AE3D-9AECC6FD9AF4}" sibTransId="{4965A01C-DCEC-4A39-B713-7664AC80FFEC}"/>
    <dgm:cxn modelId="{0AD2C3B7-C527-4BBD-8608-A315683AFD21}" type="presOf" srcId="{4965A01C-DCEC-4A39-B713-7664AC80FFEC}" destId="{43F1A160-6D85-4079-BF83-2661387C6E2D}" srcOrd="0" destOrd="0" presId="urn:microsoft.com/office/officeart/2005/8/layout/process1"/>
    <dgm:cxn modelId="{73713BB9-98C7-44F9-A28A-DA14217C8A91}" type="presOf" srcId="{15BAF81E-FF00-4D00-A31A-241C9258927B}" destId="{51D3FD1A-0D1F-4D91-B9A9-2E605C9ABB1A}" srcOrd="0" destOrd="0" presId="urn:microsoft.com/office/officeart/2005/8/layout/process1"/>
    <dgm:cxn modelId="{EF74FFC8-651F-4363-9473-11DB4C136211}" type="presParOf" srcId="{AD1B97EC-4724-42B9-9E11-DFD83D79179B}" destId="{51D3FD1A-0D1F-4D91-B9A9-2E605C9ABB1A}" srcOrd="0" destOrd="0" presId="urn:microsoft.com/office/officeart/2005/8/layout/process1"/>
    <dgm:cxn modelId="{58E1CAA2-8B09-4294-9458-3019C6F04340}" type="presParOf" srcId="{AD1B97EC-4724-42B9-9E11-DFD83D79179B}" destId="{43F1A160-6D85-4079-BF83-2661387C6E2D}" srcOrd="1" destOrd="0" presId="urn:microsoft.com/office/officeart/2005/8/layout/process1"/>
    <dgm:cxn modelId="{5CF7248C-53C5-4618-B535-897773FBD7CE}" type="presParOf" srcId="{43F1A160-6D85-4079-BF83-2661387C6E2D}" destId="{7097948E-38D9-4C81-87C0-5C8163A149E2}" srcOrd="0" destOrd="0" presId="urn:microsoft.com/office/officeart/2005/8/layout/process1"/>
    <dgm:cxn modelId="{9D8489E1-EF14-4837-9F85-B4FDC2B2D9B1}" type="presParOf" srcId="{AD1B97EC-4724-42B9-9E11-DFD83D79179B}" destId="{FBE4BAEC-5EF1-45FC-844B-8B2D4B477F74}" srcOrd="2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13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CB1ABB7-CD9C-4E85-AD5E-77E419815A16}">
      <dsp:nvSpPr>
        <dsp:cNvPr id="0" name=""/>
        <dsp:cNvSpPr/>
      </dsp:nvSpPr>
      <dsp:spPr>
        <a:xfrm>
          <a:off x="3733335" y="1916458"/>
          <a:ext cx="641414" cy="30525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08022"/>
              </a:lnTo>
              <a:lnTo>
                <a:pt x="641414" y="208022"/>
              </a:lnTo>
              <a:lnTo>
                <a:pt x="641414" y="305254"/>
              </a:lnTo>
            </a:path>
          </a:pathLst>
        </a:custGeom>
        <a:noFill/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D738469-0F97-40C6-99B9-AEAFBE30F0B1}">
      <dsp:nvSpPr>
        <dsp:cNvPr id="0" name=""/>
        <dsp:cNvSpPr/>
      </dsp:nvSpPr>
      <dsp:spPr>
        <a:xfrm>
          <a:off x="3091920" y="1916458"/>
          <a:ext cx="641414" cy="305254"/>
        </a:xfrm>
        <a:custGeom>
          <a:avLst/>
          <a:gdLst/>
          <a:ahLst/>
          <a:cxnLst/>
          <a:rect l="0" t="0" r="0" b="0"/>
          <a:pathLst>
            <a:path>
              <a:moveTo>
                <a:pt x="641414" y="0"/>
              </a:moveTo>
              <a:lnTo>
                <a:pt x="641414" y="208022"/>
              </a:lnTo>
              <a:lnTo>
                <a:pt x="0" y="208022"/>
              </a:lnTo>
              <a:lnTo>
                <a:pt x="0" y="305254"/>
              </a:lnTo>
            </a:path>
          </a:pathLst>
        </a:custGeom>
        <a:noFill/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2CA091D-4050-474F-9481-9F5DD06CCCF2}">
      <dsp:nvSpPr>
        <dsp:cNvPr id="0" name=""/>
        <dsp:cNvSpPr/>
      </dsp:nvSpPr>
      <dsp:spPr>
        <a:xfrm>
          <a:off x="2450506" y="944715"/>
          <a:ext cx="1282828" cy="30525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08022"/>
              </a:lnTo>
              <a:lnTo>
                <a:pt x="1282828" y="208022"/>
              </a:lnTo>
              <a:lnTo>
                <a:pt x="1282828" y="305254"/>
              </a:lnTo>
            </a:path>
          </a:pathLst>
        </a:custGeom>
        <a:noFill/>
        <a:ln w="12700" cap="flat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BAD7D31-8723-4873-B2D4-318A604543CD}">
      <dsp:nvSpPr>
        <dsp:cNvPr id="0" name=""/>
        <dsp:cNvSpPr/>
      </dsp:nvSpPr>
      <dsp:spPr>
        <a:xfrm>
          <a:off x="1167677" y="1916458"/>
          <a:ext cx="641414" cy="30525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08022"/>
              </a:lnTo>
              <a:lnTo>
                <a:pt x="641414" y="208022"/>
              </a:lnTo>
              <a:lnTo>
                <a:pt x="641414" y="305254"/>
              </a:lnTo>
            </a:path>
          </a:pathLst>
        </a:custGeom>
        <a:noFill/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259ADFB-1220-4532-9F64-88C0DBF9084D}">
      <dsp:nvSpPr>
        <dsp:cNvPr id="0" name=""/>
        <dsp:cNvSpPr/>
      </dsp:nvSpPr>
      <dsp:spPr>
        <a:xfrm>
          <a:off x="526263" y="1916458"/>
          <a:ext cx="641414" cy="305254"/>
        </a:xfrm>
        <a:custGeom>
          <a:avLst/>
          <a:gdLst/>
          <a:ahLst/>
          <a:cxnLst/>
          <a:rect l="0" t="0" r="0" b="0"/>
          <a:pathLst>
            <a:path>
              <a:moveTo>
                <a:pt x="641414" y="0"/>
              </a:moveTo>
              <a:lnTo>
                <a:pt x="641414" y="208022"/>
              </a:lnTo>
              <a:lnTo>
                <a:pt x="0" y="208022"/>
              </a:lnTo>
              <a:lnTo>
                <a:pt x="0" y="305254"/>
              </a:lnTo>
            </a:path>
          </a:pathLst>
        </a:custGeom>
        <a:noFill/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C9D917F-E95A-4B6E-95D9-7DD95D4C26C4}">
      <dsp:nvSpPr>
        <dsp:cNvPr id="0" name=""/>
        <dsp:cNvSpPr/>
      </dsp:nvSpPr>
      <dsp:spPr>
        <a:xfrm>
          <a:off x="1167677" y="944715"/>
          <a:ext cx="1282828" cy="305254"/>
        </a:xfrm>
        <a:custGeom>
          <a:avLst/>
          <a:gdLst/>
          <a:ahLst/>
          <a:cxnLst/>
          <a:rect l="0" t="0" r="0" b="0"/>
          <a:pathLst>
            <a:path>
              <a:moveTo>
                <a:pt x="1282828" y="0"/>
              </a:moveTo>
              <a:lnTo>
                <a:pt x="1282828" y="208022"/>
              </a:lnTo>
              <a:lnTo>
                <a:pt x="0" y="208022"/>
              </a:lnTo>
              <a:lnTo>
                <a:pt x="0" y="305254"/>
              </a:lnTo>
            </a:path>
          </a:pathLst>
        </a:custGeom>
        <a:noFill/>
        <a:ln w="12700" cap="flat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2D3BF87-DF01-4A79-9921-325403C4EDC7}">
      <dsp:nvSpPr>
        <dsp:cNvPr id="0" name=""/>
        <dsp:cNvSpPr/>
      </dsp:nvSpPr>
      <dsp:spPr>
        <a:xfrm>
          <a:off x="1925713" y="278227"/>
          <a:ext cx="1049587" cy="666487"/>
        </a:xfrm>
        <a:prstGeom prst="roundRect">
          <a:avLst>
            <a:gd name="adj" fmla="val 10000"/>
          </a:avLst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FA9F9C49-0C42-4CD9-B560-39F52E88ECC6}">
      <dsp:nvSpPr>
        <dsp:cNvPr id="0" name=""/>
        <dsp:cNvSpPr/>
      </dsp:nvSpPr>
      <dsp:spPr>
        <a:xfrm>
          <a:off x="2042333" y="389017"/>
          <a:ext cx="1049587" cy="66648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i="0" kern="1200" dirty="0"/>
            <a:t>Prediction model</a:t>
          </a:r>
          <a:endParaRPr lang="zh-CN" altLang="en-US" sz="1200" b="1" kern="1200" dirty="0"/>
        </a:p>
      </dsp:txBody>
      <dsp:txXfrm>
        <a:off x="2061854" y="408538"/>
        <a:ext cx="1010545" cy="627445"/>
      </dsp:txXfrm>
    </dsp:sp>
    <dsp:sp modelId="{F49326BB-A7C3-41EF-9AFF-5F05BC420475}">
      <dsp:nvSpPr>
        <dsp:cNvPr id="0" name=""/>
        <dsp:cNvSpPr/>
      </dsp:nvSpPr>
      <dsp:spPr>
        <a:xfrm>
          <a:off x="642884" y="1249970"/>
          <a:ext cx="1049587" cy="666487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D38C780A-3173-44F5-A44F-374F3DC26328}">
      <dsp:nvSpPr>
        <dsp:cNvPr id="0" name=""/>
        <dsp:cNvSpPr/>
      </dsp:nvSpPr>
      <dsp:spPr>
        <a:xfrm>
          <a:off x="759505" y="1360760"/>
          <a:ext cx="1049587" cy="66648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>
              <a:latin typeface="+mn-lt"/>
              <a:cs typeface="Times New Roman" panose="02020603050405020304" pitchFamily="18" charset="0"/>
            </a:rPr>
            <a:t>SUV  model</a:t>
          </a:r>
          <a:endParaRPr lang="zh-CN" altLang="en-US" sz="1200" b="1" kern="1200" dirty="0">
            <a:latin typeface="+mn-lt"/>
            <a:cs typeface="Times New Roman" panose="02020603050405020304" pitchFamily="18" charset="0"/>
          </a:endParaRPr>
        </a:p>
      </dsp:txBody>
      <dsp:txXfrm>
        <a:off x="779026" y="1380281"/>
        <a:ext cx="1010545" cy="627445"/>
      </dsp:txXfrm>
    </dsp:sp>
    <dsp:sp modelId="{35395F41-5F2A-4E74-8699-21C5A4519B23}">
      <dsp:nvSpPr>
        <dsp:cNvPr id="0" name=""/>
        <dsp:cNvSpPr/>
      </dsp:nvSpPr>
      <dsp:spPr>
        <a:xfrm>
          <a:off x="1470" y="2221713"/>
          <a:ext cx="1049587" cy="666487"/>
        </a:xfrm>
        <a:prstGeom prst="roundRect">
          <a:avLst>
            <a:gd name="adj" fmla="val 10000"/>
          </a:avLst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43074BE-26B4-4ADC-97B1-34BC046B2CFB}">
      <dsp:nvSpPr>
        <dsp:cNvPr id="0" name=""/>
        <dsp:cNvSpPr/>
      </dsp:nvSpPr>
      <dsp:spPr>
        <a:xfrm>
          <a:off x="118090" y="2332503"/>
          <a:ext cx="1049587" cy="66648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 err="1">
              <a:latin typeface="+mn-lt"/>
              <a:cs typeface="Times New Roman" panose="02020603050405020304" pitchFamily="18" charset="0"/>
            </a:rPr>
            <a:t>SUVmax</a:t>
          </a:r>
          <a:r>
            <a:rPr lang="en-US" altLang="zh-CN" sz="1200" b="1" kern="1200" dirty="0">
              <a:latin typeface="+mn-lt"/>
              <a:cs typeface="Times New Roman" panose="02020603050405020304" pitchFamily="18" charset="0"/>
            </a:rPr>
            <a:t> model</a:t>
          </a:r>
          <a:endParaRPr lang="zh-CN" altLang="en-US" sz="1200" b="1" kern="1200" dirty="0">
            <a:latin typeface="+mn-lt"/>
            <a:cs typeface="Times New Roman" panose="02020603050405020304" pitchFamily="18" charset="0"/>
          </a:endParaRPr>
        </a:p>
      </dsp:txBody>
      <dsp:txXfrm>
        <a:off x="137611" y="2352024"/>
        <a:ext cx="1010545" cy="627445"/>
      </dsp:txXfrm>
    </dsp:sp>
    <dsp:sp modelId="{9FCFD946-4BCA-4E6F-9BCA-3F1A51800425}">
      <dsp:nvSpPr>
        <dsp:cNvPr id="0" name=""/>
        <dsp:cNvSpPr/>
      </dsp:nvSpPr>
      <dsp:spPr>
        <a:xfrm>
          <a:off x="1284298" y="2221713"/>
          <a:ext cx="1049587" cy="666487"/>
        </a:xfrm>
        <a:prstGeom prst="roundRect">
          <a:avLst>
            <a:gd name="adj" fmla="val 10000"/>
          </a:avLst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0CF5837-63F2-40BE-8D06-788E5E6E3518}">
      <dsp:nvSpPr>
        <dsp:cNvPr id="0" name=""/>
        <dsp:cNvSpPr/>
      </dsp:nvSpPr>
      <dsp:spPr>
        <a:xfrm>
          <a:off x="1400919" y="2332503"/>
          <a:ext cx="1049587" cy="66648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>
              <a:latin typeface="+mn-lt"/>
              <a:cs typeface="Times New Roman" panose="02020603050405020304" pitchFamily="18" charset="0"/>
            </a:rPr>
            <a:t>SUL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altLang="zh-CN" sz="1200" b="1" kern="1200" dirty="0">
              <a:latin typeface="+mn-lt"/>
              <a:cs typeface="Times New Roman" panose="02020603050405020304" pitchFamily="18" charset="0"/>
            </a:rPr>
            <a:t>model</a:t>
          </a:r>
          <a:endParaRPr lang="zh-CN" altLang="en-US" sz="1200" b="1" kern="1200" dirty="0">
            <a:latin typeface="+mn-lt"/>
            <a:cs typeface="Times New Roman" panose="02020603050405020304" pitchFamily="18" charset="0"/>
          </a:endParaRPr>
        </a:p>
      </dsp:txBody>
      <dsp:txXfrm>
        <a:off x="1420440" y="2352024"/>
        <a:ext cx="1010545" cy="627445"/>
      </dsp:txXfrm>
    </dsp:sp>
    <dsp:sp modelId="{6C684515-4B97-4084-BE3D-05A47E474813}">
      <dsp:nvSpPr>
        <dsp:cNvPr id="0" name=""/>
        <dsp:cNvSpPr/>
      </dsp:nvSpPr>
      <dsp:spPr>
        <a:xfrm>
          <a:off x="3208541" y="1249970"/>
          <a:ext cx="1049587" cy="666487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BA627587-A4F6-4022-AB11-8A47B4A414AD}">
      <dsp:nvSpPr>
        <dsp:cNvPr id="0" name=""/>
        <dsp:cNvSpPr/>
      </dsp:nvSpPr>
      <dsp:spPr>
        <a:xfrm>
          <a:off x="3325162" y="1360760"/>
          <a:ext cx="1049587" cy="66648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latin typeface="+mn-lt"/>
              <a:cs typeface="Times New Roman" panose="02020603050405020304" pitchFamily="18" charset="0"/>
            </a:rPr>
            <a:t>texture parameter model </a:t>
          </a:r>
          <a:endParaRPr lang="zh-CN" altLang="en-US" sz="1200" b="1" kern="1200" dirty="0">
            <a:latin typeface="+mn-lt"/>
            <a:cs typeface="Times New Roman" panose="02020603050405020304" pitchFamily="18" charset="0"/>
          </a:endParaRPr>
        </a:p>
      </dsp:txBody>
      <dsp:txXfrm>
        <a:off x="3344683" y="1380281"/>
        <a:ext cx="1010545" cy="627445"/>
      </dsp:txXfrm>
    </dsp:sp>
    <dsp:sp modelId="{C491A8D0-AC33-4AD4-9A35-F35FFE23BFF9}">
      <dsp:nvSpPr>
        <dsp:cNvPr id="0" name=""/>
        <dsp:cNvSpPr/>
      </dsp:nvSpPr>
      <dsp:spPr>
        <a:xfrm>
          <a:off x="2567127" y="2221713"/>
          <a:ext cx="1049587" cy="666487"/>
        </a:xfrm>
        <a:prstGeom prst="roundRect">
          <a:avLst>
            <a:gd name="adj" fmla="val 10000"/>
          </a:avLst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EFB62EB-85B0-47FE-BB1C-7207EEEC9BD1}">
      <dsp:nvSpPr>
        <dsp:cNvPr id="0" name=""/>
        <dsp:cNvSpPr/>
      </dsp:nvSpPr>
      <dsp:spPr>
        <a:xfrm>
          <a:off x="2683748" y="2332503"/>
          <a:ext cx="1049587" cy="66648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latin typeface="+mn-lt"/>
              <a:cs typeface="Times New Roman" panose="02020603050405020304" pitchFamily="18" charset="0"/>
            </a:rPr>
            <a:t>PET/CT  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latin typeface="+mn-lt"/>
              <a:cs typeface="Times New Roman" panose="02020603050405020304" pitchFamily="18" charset="0"/>
            </a:rPr>
            <a:t>model </a:t>
          </a:r>
          <a:endParaRPr lang="zh-CN" altLang="en-US" sz="1200" b="1" kern="1200" dirty="0">
            <a:latin typeface="+mn-lt"/>
            <a:cs typeface="Times New Roman" panose="02020603050405020304" pitchFamily="18" charset="0"/>
          </a:endParaRPr>
        </a:p>
      </dsp:txBody>
      <dsp:txXfrm>
        <a:off x="2703269" y="2352024"/>
        <a:ext cx="1010545" cy="627445"/>
      </dsp:txXfrm>
    </dsp:sp>
    <dsp:sp modelId="{C8846952-BB46-4C35-9037-81546866015C}">
      <dsp:nvSpPr>
        <dsp:cNvPr id="0" name=""/>
        <dsp:cNvSpPr/>
      </dsp:nvSpPr>
      <dsp:spPr>
        <a:xfrm>
          <a:off x="3849956" y="2221713"/>
          <a:ext cx="1049587" cy="666487"/>
        </a:xfrm>
        <a:prstGeom prst="roundRect">
          <a:avLst>
            <a:gd name="adj" fmla="val 10000"/>
          </a:avLst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8F7FDB7-B91A-4676-8C2D-68771B586934}">
      <dsp:nvSpPr>
        <dsp:cNvPr id="0" name=""/>
        <dsp:cNvSpPr/>
      </dsp:nvSpPr>
      <dsp:spPr>
        <a:xfrm>
          <a:off x="3966576" y="2332503"/>
          <a:ext cx="1049587" cy="666487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latin typeface="+mn-lt"/>
              <a:cs typeface="Times New Roman" panose="02020603050405020304" pitchFamily="18" charset="0"/>
            </a:rPr>
            <a:t>PET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 dirty="0">
              <a:latin typeface="+mn-lt"/>
              <a:cs typeface="Times New Roman" panose="02020603050405020304" pitchFamily="18" charset="0"/>
            </a:rPr>
            <a:t>model</a:t>
          </a:r>
          <a:endParaRPr lang="zh-CN" altLang="en-US" sz="1200" b="1" kern="1200" dirty="0">
            <a:latin typeface="+mn-lt"/>
            <a:cs typeface="Times New Roman" panose="02020603050405020304" pitchFamily="18" charset="0"/>
          </a:endParaRPr>
        </a:p>
      </dsp:txBody>
      <dsp:txXfrm>
        <a:off x="3986097" y="2352024"/>
        <a:ext cx="1010545" cy="627445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1D3FD1A-0D1F-4D91-B9A9-2E605C9ABB1A}">
      <dsp:nvSpPr>
        <dsp:cNvPr id="0" name=""/>
        <dsp:cNvSpPr/>
      </dsp:nvSpPr>
      <dsp:spPr>
        <a:xfrm>
          <a:off x="494" y="55268"/>
          <a:ext cx="1053919" cy="632351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>
          <a:noFill/>
        </a:ln>
        <a:effectLst/>
        <a:sp3d extrusionH="50600" prstMaterial="metal">
          <a:bevelT w="101600" h="80600" prst="relaxedInset"/>
          <a:bevelB w="80600" h="80600" prst="relaxedInset"/>
        </a:sp3d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/>
            <a:t>SUL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/>
            <a:t> model</a:t>
          </a:r>
          <a:endParaRPr lang="zh-CN" altLang="en-US" sz="1200" b="1" kern="1200" dirty="0"/>
        </a:p>
      </dsp:txBody>
      <dsp:txXfrm>
        <a:off x="19015" y="73789"/>
        <a:ext cx="1016877" cy="595309"/>
      </dsp:txXfrm>
    </dsp:sp>
    <dsp:sp modelId="{43F1A160-6D85-4079-BF83-2661387C6E2D}">
      <dsp:nvSpPr>
        <dsp:cNvPr id="0" name=""/>
        <dsp:cNvSpPr/>
      </dsp:nvSpPr>
      <dsp:spPr>
        <a:xfrm>
          <a:off x="1159806" y="240757"/>
          <a:ext cx="223431" cy="261372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  <a:sp3d z="-110000">
          <a:bevelT w="40600" h="20600" prst="relaxedInset"/>
        </a:sp3d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zh-CN" altLang="en-US" sz="1100" kern="1200"/>
        </a:p>
      </dsp:txBody>
      <dsp:txXfrm>
        <a:off x="1159806" y="293031"/>
        <a:ext cx="156402" cy="156824"/>
      </dsp:txXfrm>
    </dsp:sp>
    <dsp:sp modelId="{FBE4BAEC-5EF1-45FC-844B-8B2D4B477F74}">
      <dsp:nvSpPr>
        <dsp:cNvPr id="0" name=""/>
        <dsp:cNvSpPr/>
      </dsp:nvSpPr>
      <dsp:spPr>
        <a:xfrm>
          <a:off x="1475981" y="55268"/>
          <a:ext cx="1053919" cy="632351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>
          <a:noFill/>
        </a:ln>
        <a:effectLst/>
        <a:sp3d extrusionH="50600" prstMaterial="metal">
          <a:bevelT w="101600" h="80600" prst="relaxedInset"/>
          <a:bevelB w="80600" h="80600" prst="relaxedInset"/>
        </a:sp3d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/>
            <a:t>PET/CT 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1200" b="1" kern="1200" dirty="0"/>
            <a:t>model</a:t>
          </a:r>
          <a:endParaRPr lang="zh-CN" altLang="en-US" sz="1200" b="1" kern="1200" dirty="0"/>
        </a:p>
      </dsp:txBody>
      <dsp:txXfrm>
        <a:off x="1494502" y="73789"/>
        <a:ext cx="1016877" cy="59530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3d7">
  <dgm:title val=""/>
  <dgm:desc val=""/>
  <dgm:catLst>
    <dgm:cat type="3D" pri="11700"/>
  </dgm:catLst>
  <dgm:scene3d>
    <a:camera prst="perspectiveLeft" zoom="91000"/>
    <a:lightRig rig="threePt" dir="t">
      <a:rot lat="0" lon="0" rev="20640000"/>
    </a:lightRig>
  </dgm:scene3d>
  <dgm:styleLbl name="node0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threePt" dir="t"/>
    </dgm:scene3d>
    <dgm:sp3d extrusionH="50600" prstMaterial="clear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 extrusionH="50600" prstMaterial="metal">
      <a:bevelT w="101600" h="80600" prst="relaxedInset"/>
      <a:bevelB w="80600" h="80600" prst="relaxedInset"/>
    </dgm:sp3d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threePt" dir="t"/>
    </dgm:scene3d>
    <dgm:sp3d extrusionH="50600" prstMaterial="metal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 z="57200" extrusionH="10600" prstMaterial="plastic">
      <a:bevelT w="101600" h="8600" prst="relaxedInset"/>
      <a:bevelB w="8600" h="8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 z="-211800" extrusionH="10600" prstMaterial="plastic">
      <a:bevelT w="101600" h="8600" prst="relaxedInset"/>
      <a:bevelB w="8600" h="8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 z="-110000">
      <a:bevelT w="40600" h="20600" prst="relaxedInset"/>
    </dgm:sp3d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SibTrans2D1">
    <dgm:scene3d>
      <a:camera prst="orthographicFront"/>
      <a:lightRig rig="threePt" dir="t"/>
    </dgm:scene3d>
    <dgm:sp3d z="10600">
      <a:bevelT w="40600" h="20600" prst="relaxedInset"/>
    </dgm:sp3d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ibTrans2D1">
    <dgm:scene3d>
      <a:camera prst="orthographicFront"/>
      <a:lightRig rig="threePt" dir="t"/>
    </dgm:scene3d>
    <dgm:sp3d z="-211800">
      <a:bevelT w="40600" h="20600" prst="relaxedInset"/>
    </dgm:sp3d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1D1">
    <dgm:scene3d>
      <a:camera prst="orthographicFront"/>
      <a:lightRig rig="threePt" dir="t"/>
    </dgm:scene3d>
    <dgm:sp3d z="-110000"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 z="10000"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threePt" dir="t"/>
    </dgm:scene3d>
    <dgm:sp3d extrusionH="50600" prstMaterial="plastic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 z="-110000">
      <a:bevelT w="40600" h="20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2D2">
    <dgm:scene3d>
      <a:camera prst="orthographicFront"/>
      <a:lightRig rig="threePt" dir="t"/>
    </dgm:scene3d>
    <dgm:sp3d z="-110000">
      <a:bevelT w="40600" h="20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2D3">
    <dgm:scene3d>
      <a:camera prst="orthographicFront"/>
      <a:lightRig rig="threePt" dir="t"/>
    </dgm:scene3d>
    <dgm:sp3d z="-110000"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2D4">
    <dgm:scene3d>
      <a:camera prst="orthographicFront"/>
      <a:lightRig rig="threePt" dir="t"/>
    </dgm:scene3d>
    <dgm:sp3d z="-110000"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parChTrans1D1">
    <dgm:scene3d>
      <a:camera prst="orthographicFront"/>
      <a:lightRig rig="threePt" dir="t"/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 z="-110000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 z="57200" extrusionH="600" contourW="3000">
      <a:bevelT w="48600" h="18600" prst="relaxedInset"/>
      <a:bevelB w="48600" h="8600" prst="relaxedInset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 z="-161800" extrusionH="10600" prstMaterial="matte">
      <a:bevelT w="90600" h="18600" prst="softRound"/>
      <a:bevelB w="48600" h="8600" prst="relaxedInset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 extrusionH="50600">
      <a:bevelT w="101600" h="80600"/>
      <a:bevelB w="80600" h="80600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 extrusionH="50600">
      <a:bevelT w="101600" h="80600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 z="-161800" extrusionH="10600" prstMaterial="matte">
      <a:bevelT w="90600" h="18600" prst="softRound"/>
      <a:bevelB w="48600" h="8600" prst="relaxedInset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 z="57200" extrusionH="600" contourW="3000">
      <a:bevelT w="48600" h="18600" prst="relaxedInset"/>
      <a:bevelB w="48600" h="8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 extrusionH="50600" contourW="3000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 z="-161800" extrusionH="10600" contourW="3000">
      <a:bevelT w="48600" h="8600" prst="softRound"/>
      <a:bevelB w="48600" h="8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 z="57200" extrusionH="600" contourW="3000">
      <a:bevelT w="48600" h="18600" prst="relaxedInset"/>
      <a:bevelB w="48600" h="8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 extrusionH="50600" contourW="3000">
      <a:bevelT w="101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 z="-161800" extrusionH="10600" contourW="3000">
      <a:bevelT w="48600" h="8600" prst="relaxedInset"/>
      <a:bevelB w="48600" h="8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 z="57200" extrusionH="600" contourW="3000">
      <a:bevelT w="48600" h="18600" prst="relaxedInset"/>
      <a:bevelB w="48600" h="8600" prst="relaxedInset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 z="57200" extrusionH="600" contourW="3000">
      <a:bevelT w="48600" h="18600" prst="relaxedInset"/>
      <a:bevelB w="48600" h="8600" prst="relaxedInset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 z="57200" extrusionH="600" contourW="3000">
      <a:bevelT w="48600" h="18600" prst="relaxedInset"/>
      <a:bevelB w="48600" h="8600" prst="relaxedInset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 z="57200" extrusionH="600" contourW="3000">
      <a:bevelT w="48600" h="18600" prst="relaxedInset"/>
      <a:bevelB w="48600" h="8600" prst="relaxedInset"/>
    </dgm:sp3d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 z="-161800" extrusionH="600" contourW="3000">
      <a:bevelT w="48600" h="18600" prst="relaxedInset"/>
      <a:bevelB w="48600" h="8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 extrusionH="50600">
      <a:bevelT w="80600" h="80600" prst="relaxedInset"/>
      <a:bevelB w="80600" h="80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 z="-152400" prstMaterial="matte"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 z="57200" extrusionH="600" contourW="3000" prstMaterial="plastic">
      <a:bevelT w="80600" h="18600" prst="relaxedInset"/>
      <a:bevelB w="80600" h="8600" prst="relaxedInset"/>
    </dgm:sp3d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890ED-11B8-4800-B8B2-72C7F4E99478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25488" y="1143000"/>
            <a:ext cx="5407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7101A8-4275-45CB-8E2F-D2818FB70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8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23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89856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42069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1159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85844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714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939720"/>
            <a:ext cx="7543800" cy="1999062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015873"/>
            <a:ext cx="7543800" cy="1386318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13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47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305708"/>
            <a:ext cx="2168843" cy="48660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05708"/>
            <a:ext cx="6380798" cy="486606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95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431510"/>
            <a:ext cx="8675370" cy="2388507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842614"/>
            <a:ext cx="8675370" cy="1256059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61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05708"/>
            <a:ext cx="8675370" cy="11098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407585"/>
            <a:ext cx="4255174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97421"/>
            <a:ext cx="4255174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407585"/>
            <a:ext cx="4276130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97421"/>
            <a:ext cx="4276130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5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826740"/>
            <a:ext cx="5092065" cy="4080533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86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826740"/>
            <a:ext cx="5092065" cy="4080533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05708"/>
            <a:ext cx="8675370" cy="1109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528538"/>
            <a:ext cx="8675370" cy="3643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559BE-96A6-4C40-8576-E268AFCD6E8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321972"/>
            <a:ext cx="339471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6104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13" Type="http://schemas.microsoft.com/office/2007/relationships/diagramDrawing" Target="../diagrams/drawing2.xml"/><Relationship Id="rId3" Type="http://schemas.openxmlformats.org/officeDocument/2006/relationships/image" Target="../media/image1.tiff"/><Relationship Id="rId7" Type="http://schemas.openxmlformats.org/officeDocument/2006/relationships/diagramColors" Target="../diagrams/colors1.xml"/><Relationship Id="rId12" Type="http://schemas.openxmlformats.org/officeDocument/2006/relationships/diagramColors" Target="../diagrams/colors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diagramQuickStyle" Target="../diagrams/quickStyle1.xml"/><Relationship Id="rId11" Type="http://schemas.openxmlformats.org/officeDocument/2006/relationships/diagramQuickStyle" Target="../diagrams/quickStyle2.xml"/><Relationship Id="rId5" Type="http://schemas.openxmlformats.org/officeDocument/2006/relationships/diagramLayout" Target="../diagrams/layout1.xml"/><Relationship Id="rId10" Type="http://schemas.openxmlformats.org/officeDocument/2006/relationships/diagramLayout" Target="../diagrams/layout2.xml"/><Relationship Id="rId4" Type="http://schemas.openxmlformats.org/officeDocument/2006/relationships/diagramData" Target="../diagrams/data1.xml"/><Relationship Id="rId9" Type="http://schemas.openxmlformats.org/officeDocument/2006/relationships/diagramData" Target="../diagrams/data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tiff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229215"/>
            <a:ext cx="952864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2800" b="1" kern="100" baseline="300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18</a:t>
            </a:r>
            <a:r>
              <a:rPr lang="en-US" altLang="zh-CN" sz="2800" b="1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F-FDG texture analysis predicts the pathological Fuhrman nuclear grade of clear cell renal cell carcinoma</a:t>
            </a:r>
            <a:endParaRPr lang="zh-CN" altLang="zh-CN" sz="2800" b="1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4001" y="5316800"/>
            <a:ext cx="24340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Zhang </a:t>
            </a:r>
            <a:r>
              <a:rPr lang="en-US" altLang="zh-CN" dirty="0" err="1"/>
              <a:t>linhan</a:t>
            </a:r>
            <a:r>
              <a:rPr lang="en-US" altLang="zh-CN" dirty="0"/>
              <a:t> </a:t>
            </a:r>
            <a:r>
              <a:rPr lang="en-US" dirty="0"/>
              <a:t>et al; 2021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534827" y="413280"/>
            <a:ext cx="432418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br>
              <a:rPr lang="en-US" altLang="zh-CN" sz="24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</a:br>
            <a:endParaRPr lang="en-US" altLang="zh-CN" sz="2400" b="0" i="0" dirty="0">
              <a:effectLst/>
              <a:latin typeface="Arial" panose="020B0604020202020204" pitchFamily="34" charset="0"/>
            </a:endParaRPr>
          </a:p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altLang="zh-CN" sz="2400" b="0" i="0" dirty="0">
                <a:effectLst/>
                <a:cs typeface="Times New Roman" panose="02020603050405020304" pitchFamily="18" charset="0"/>
              </a:rPr>
              <a:t>Four predictive models were established to evaluate the Fuhrman grade of renal clear cell carcinoma</a:t>
            </a:r>
            <a:r>
              <a:rPr lang="en-US" altLang="zh-CN" sz="2400" dirty="0">
                <a:cs typeface="Times New Roman" panose="02020603050405020304" pitchFamily="18" charset="0"/>
              </a:rPr>
              <a:t>.</a:t>
            </a:r>
            <a:r>
              <a:rPr lang="en-US" altLang="zh-CN" sz="24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en-US" altLang="zh-CN" sz="2400" b="0" i="0" dirty="0">
              <a:effectLst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250" y="4828542"/>
            <a:ext cx="3940150" cy="857590"/>
          </a:xfrm>
          <a:prstGeom prst="rect">
            <a:avLst/>
          </a:prstGeom>
        </p:spPr>
      </p:pic>
      <p:graphicFrame>
        <p:nvGraphicFramePr>
          <p:cNvPr id="6" name="图示 5">
            <a:extLst>
              <a:ext uri="{FF2B5EF4-FFF2-40B4-BE49-F238E27FC236}">
                <a16:creationId xmlns:a16="http://schemas.microsoft.com/office/drawing/2014/main" id="{E3E566FE-2AC0-4C1F-94BB-7B09BCA752B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17599774"/>
              </p:ext>
            </p:extLst>
          </p:nvPr>
        </p:nvGraphicFramePr>
        <p:xfrm>
          <a:off x="244001" y="1082994"/>
          <a:ext cx="5017634" cy="327721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46A3B13B-89F4-4B3B-ABCB-5A303B6BB300}"/>
              </a:ext>
            </a:extLst>
          </p:cNvPr>
          <p:cNvSpPr txBox="1"/>
          <p:nvPr/>
        </p:nvSpPr>
        <p:spPr>
          <a:xfrm>
            <a:off x="5534827" y="2750242"/>
            <a:ext cx="4642756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altLang="zh-CN" sz="2400" dirty="0">
                <a:cs typeface="Times New Roman" panose="02020603050405020304" pitchFamily="18" charset="0"/>
              </a:rPr>
              <a:t>This is the </a:t>
            </a:r>
            <a:r>
              <a:rPr lang="en-US" altLang="zh-CN" sz="2400" b="1" dirty="0">
                <a:solidFill>
                  <a:srgbClr val="FF0000"/>
                </a:solidFill>
                <a:cs typeface="Times New Roman" panose="02020603050405020304" pitchFamily="18" charset="0"/>
              </a:rPr>
              <a:t>first</a:t>
            </a:r>
            <a:r>
              <a:rPr lang="en-US" altLang="zh-CN" sz="2400" dirty="0">
                <a:cs typeface="Times New Roman" panose="02020603050405020304" pitchFamily="18" charset="0"/>
              </a:rPr>
              <a:t> article to study the prediction of </a:t>
            </a:r>
            <a:r>
              <a:rPr lang="en-US" altLang="zh-CN" sz="2400" dirty="0" err="1">
                <a:cs typeface="Times New Roman" panose="02020603050405020304" pitchFamily="18" charset="0"/>
              </a:rPr>
              <a:t>ccRCC</a:t>
            </a:r>
            <a:r>
              <a:rPr lang="en-US" altLang="zh-CN" sz="2400" dirty="0">
                <a:cs typeface="Times New Roman" panose="02020603050405020304" pitchFamily="18" charset="0"/>
              </a:rPr>
              <a:t> Fuhrman nuclear grade by PET/CT radiological characteristics</a:t>
            </a:r>
            <a:endParaRPr lang="zh-CN" altLang="en-US" sz="2400" dirty="0">
              <a:cs typeface="Times New Roman" panose="02020603050405020304" pitchFamily="18" charset="0"/>
            </a:endParaRPr>
          </a:p>
        </p:txBody>
      </p:sp>
      <p:graphicFrame>
        <p:nvGraphicFramePr>
          <p:cNvPr id="3" name="图示 2">
            <a:extLst>
              <a:ext uri="{FF2B5EF4-FFF2-40B4-BE49-F238E27FC236}">
                <a16:creationId xmlns:a16="http://schemas.microsoft.com/office/drawing/2014/main" id="{798094F0-3D8A-4B54-8A2D-5F440CA1ED8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92492219"/>
              </p:ext>
            </p:extLst>
          </p:nvPr>
        </p:nvGraphicFramePr>
        <p:xfrm>
          <a:off x="1412867" y="4335000"/>
          <a:ext cx="2530396" cy="74288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9" r:lo="rId10" r:qs="rId11" r:cs="rId12"/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650F5492-0868-4F7C-B692-B0B3DB45A799}"/>
              </a:ext>
            </a:extLst>
          </p:cNvPr>
          <p:cNvSpPr txBox="1"/>
          <p:nvPr/>
        </p:nvSpPr>
        <p:spPr>
          <a:xfrm>
            <a:off x="89613" y="1438491"/>
            <a:ext cx="2678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ea typeface="宋体" panose="02010600030101010101" pitchFamily="2" charset="-122"/>
              </a:rPr>
              <a:t>R</a:t>
            </a:r>
            <a:r>
              <a:rPr lang="en-US" altLang="zh-CN" sz="1200" b="1" dirty="0">
                <a:effectLst/>
                <a:ea typeface="宋体" panose="02010600030101010101" pitchFamily="2" charset="-122"/>
              </a:rPr>
              <a:t>etrospective analysis</a:t>
            </a:r>
            <a:endParaRPr lang="zh-CN" altLang="en-US" sz="12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E2F28CB-E498-4484-B5C5-164A163C2528}"/>
              </a:ext>
            </a:extLst>
          </p:cNvPr>
          <p:cNvSpPr txBox="1"/>
          <p:nvPr/>
        </p:nvSpPr>
        <p:spPr>
          <a:xfrm>
            <a:off x="0" y="4520494"/>
            <a:ext cx="19010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b="1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Prospective verification</a:t>
            </a:r>
            <a:endParaRPr lang="zh-CN" altLang="zh-CN" sz="12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6295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64F69A-6301-47BA-858F-EA4A1DB0D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0570" y="298330"/>
            <a:ext cx="8675370" cy="1109852"/>
          </a:xfrm>
        </p:spPr>
        <p:txBody>
          <a:bodyPr>
            <a:noAutofit/>
          </a:bodyPr>
          <a:lstStyle/>
          <a:p>
            <a:r>
              <a:rPr lang="en-US" altLang="zh-CN" sz="2800" b="1" kern="0" dirty="0">
                <a:effectLst/>
                <a:latin typeface="+mn-lt"/>
                <a:ea typeface="仿宋" panose="02010609060101010101" pitchFamily="49" charset="-122"/>
                <a:cs typeface="Times New Roman" panose="02020603050405020304" pitchFamily="18" charset="0"/>
              </a:rPr>
              <a:t>Differences of conventional PET parameters in the Fuhrman grades of </a:t>
            </a:r>
            <a:r>
              <a:rPr lang="en-US" altLang="zh-CN" sz="2800" b="1" kern="0" dirty="0" err="1">
                <a:effectLst/>
                <a:latin typeface="+mn-lt"/>
                <a:ea typeface="仿宋" panose="02010609060101010101" pitchFamily="49" charset="-122"/>
                <a:cs typeface="Times New Roman" panose="02020603050405020304" pitchFamily="18" charset="0"/>
              </a:rPr>
              <a:t>ccRCC</a:t>
            </a:r>
            <a:br>
              <a:rPr lang="zh-CN" altLang="zh-CN" sz="2800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lang="zh-CN" altLang="en-US" sz="2800" dirty="0"/>
          </a:p>
        </p:txBody>
      </p:sp>
      <p:graphicFrame>
        <p:nvGraphicFramePr>
          <p:cNvPr id="7" name="内容占位符 6">
            <a:extLst>
              <a:ext uri="{FF2B5EF4-FFF2-40B4-BE49-F238E27FC236}">
                <a16:creationId xmlns:a16="http://schemas.microsoft.com/office/drawing/2014/main" id="{764DCFDA-9639-4BB8-91C4-8DD55E1F51D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32558305"/>
              </p:ext>
            </p:extLst>
          </p:nvPr>
        </p:nvGraphicFramePr>
        <p:xfrm>
          <a:off x="152131" y="1366683"/>
          <a:ext cx="6371951" cy="308277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66604">
                  <a:extLst>
                    <a:ext uri="{9D8B030D-6E8A-4147-A177-3AD203B41FA5}">
                      <a16:colId xmlns:a16="http://schemas.microsoft.com/office/drawing/2014/main" val="326287757"/>
                    </a:ext>
                  </a:extLst>
                </a:gridCol>
                <a:gridCol w="1677233">
                  <a:extLst>
                    <a:ext uri="{9D8B030D-6E8A-4147-A177-3AD203B41FA5}">
                      <a16:colId xmlns:a16="http://schemas.microsoft.com/office/drawing/2014/main" val="2747625937"/>
                    </a:ext>
                  </a:extLst>
                </a:gridCol>
                <a:gridCol w="1708436">
                  <a:extLst>
                    <a:ext uri="{9D8B030D-6E8A-4147-A177-3AD203B41FA5}">
                      <a16:colId xmlns:a16="http://schemas.microsoft.com/office/drawing/2014/main" val="1929582725"/>
                    </a:ext>
                  </a:extLst>
                </a:gridCol>
                <a:gridCol w="759839">
                  <a:extLst>
                    <a:ext uri="{9D8B030D-6E8A-4147-A177-3AD203B41FA5}">
                      <a16:colId xmlns:a16="http://schemas.microsoft.com/office/drawing/2014/main" val="4225187848"/>
                    </a:ext>
                  </a:extLst>
                </a:gridCol>
                <a:gridCol w="759839">
                  <a:extLst>
                    <a:ext uri="{9D8B030D-6E8A-4147-A177-3AD203B41FA5}">
                      <a16:colId xmlns:a16="http://schemas.microsoft.com/office/drawing/2014/main" val="1393178422"/>
                    </a:ext>
                  </a:extLst>
                </a:gridCol>
              </a:tblGrid>
              <a:tr h="501741"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onventional</a:t>
                      </a:r>
                    </a:p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parameters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Low grade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=27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High grade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=22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kern="100" dirty="0">
                          <a:effectLst/>
                          <a:latin typeface="+mn-lt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UC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06852994"/>
                  </a:ext>
                </a:extLst>
              </a:tr>
              <a:tr h="516207"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 err="1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UVmin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75</a:t>
                      </a:r>
                    </a:p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0.53~1.02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96</a:t>
                      </a:r>
                    </a:p>
                    <a:p>
                      <a:pPr algn="ctr"/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51~1.35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ea typeface="仿宋" panose="02010609060101010101" pitchFamily="49" charset="-122"/>
                          <a:cs typeface="Times New Roman" panose="02020603050405020304" pitchFamily="18" charset="0"/>
                        </a:rPr>
                        <a:t>0.594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26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16197076"/>
                  </a:ext>
                </a:extLst>
              </a:tr>
              <a:tr h="516207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UVmean</a:t>
                      </a:r>
                      <a:endParaRPr lang="zh-CN" sz="16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.75</a:t>
                      </a:r>
                    </a:p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1.41~2.15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.36</a:t>
                      </a:r>
                    </a:p>
                    <a:p>
                      <a:pPr algn="ctr"/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.94~2.95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仿宋" panose="02010609060101010101" pitchFamily="49" charset="-122"/>
                          <a:cs typeface="Times New Roman" panose="02020603050405020304" pitchFamily="18" charset="0"/>
                        </a:rPr>
                        <a:t>0.779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01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7770525"/>
                  </a:ext>
                </a:extLst>
              </a:tr>
              <a:tr h="516207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UVmax</a:t>
                      </a:r>
                      <a:endParaRPr lang="zh-CN" sz="16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3.42</a:t>
                      </a:r>
                    </a:p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2.59~3.74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4.72</a:t>
                      </a:r>
                    </a:p>
                    <a:p>
                      <a:pPr algn="ctr"/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3.56~5.72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仿宋" panose="02010609060101010101" pitchFamily="49" charset="-122"/>
                          <a:cs typeface="Times New Roman" panose="02020603050405020304" pitchFamily="18" charset="0"/>
                        </a:rPr>
                        <a:t>0.803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01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717588079"/>
                  </a:ext>
                </a:extLst>
              </a:tr>
              <a:tr h="516207"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TLG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91.32</a:t>
                      </a:r>
                    </a:p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27.81~123.15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48.38</a:t>
                      </a:r>
                    </a:p>
                    <a:p>
                      <a:pPr algn="ctr"/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8.78~589.76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仿宋" panose="02010609060101010101" pitchFamily="49" charset="-122"/>
                          <a:cs typeface="Times New Roman" panose="02020603050405020304" pitchFamily="18" charset="0"/>
                        </a:rPr>
                        <a:t>0.685</a:t>
                      </a:r>
                      <a:endParaRPr lang="zh-CN" sz="16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27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88836427"/>
                  </a:ext>
                </a:extLst>
              </a:tr>
              <a:tr h="51620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kern="100" dirty="0">
                          <a:effectLst/>
                          <a:latin typeface="+mn-lt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UL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.39</a:t>
                      </a:r>
                    </a:p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(1.22~1.63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.13</a:t>
                      </a:r>
                    </a:p>
                    <a:p>
                      <a:pPr algn="ctr"/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.56~2.91</a:t>
                      </a:r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）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仿宋" panose="02010609060101010101" pitchFamily="49" charset="-122"/>
                          <a:cs typeface="Times New Roman" panose="02020603050405020304" pitchFamily="18" charset="0"/>
                        </a:rPr>
                        <a:t>0.818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zh-CN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600" kern="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.001</a:t>
                      </a:r>
                      <a:endParaRPr lang="zh-CN" sz="16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93450040"/>
                  </a:ext>
                </a:extLst>
              </a:tr>
            </a:tbl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347CDD19-CB6A-410B-AE51-BC3F12C8A2E9}"/>
              </a:ext>
            </a:extLst>
          </p:cNvPr>
          <p:cNvSpPr txBox="1"/>
          <p:nvPr/>
        </p:nvSpPr>
        <p:spPr>
          <a:xfrm>
            <a:off x="367402" y="4470232"/>
            <a:ext cx="57508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600" i="1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Note. P</a:t>
            </a:r>
            <a:r>
              <a:rPr lang="en-US" altLang="zh-CN" sz="1600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   refers to the significance for ROC curves</a:t>
            </a:r>
            <a:endParaRPr lang="zh-CN" altLang="zh-CN" sz="16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6349388-A8A1-4D60-B18A-36AD46926271}"/>
              </a:ext>
            </a:extLst>
          </p:cNvPr>
          <p:cNvSpPr txBox="1"/>
          <p:nvPr/>
        </p:nvSpPr>
        <p:spPr>
          <a:xfrm>
            <a:off x="6708504" y="1366683"/>
            <a:ext cx="3520018" cy="29238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The ability to predict </a:t>
            </a:r>
            <a:r>
              <a:rPr lang="en-US" altLang="zh-CN" sz="2400" kern="100" dirty="0" err="1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ccRCC</a:t>
            </a:r>
            <a:r>
              <a:rPr lang="en-US" altLang="zh-CN" sz="2400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 Fuhrman nuclear grade according to AUROC routine parameters is ranked as: </a:t>
            </a:r>
          </a:p>
          <a:p>
            <a:endParaRPr lang="en-US" altLang="zh-CN" sz="16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2400" b="1" kern="100" dirty="0">
                <a:solidFill>
                  <a:srgbClr val="FF0000"/>
                </a:solidFill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SUL</a:t>
            </a:r>
            <a:r>
              <a:rPr lang="zh-CN" altLang="zh-CN" sz="2400" b="1" kern="100" dirty="0">
                <a:solidFill>
                  <a:srgbClr val="FF0000"/>
                </a:solidFill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＞</a:t>
            </a:r>
            <a:r>
              <a:rPr lang="en-US" altLang="zh-CN" sz="2400" b="1" kern="100" dirty="0" err="1">
                <a:solidFill>
                  <a:srgbClr val="FF0000"/>
                </a:solidFill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SUVmax</a:t>
            </a:r>
            <a:r>
              <a:rPr lang="zh-CN" altLang="zh-CN" sz="2400" b="1" kern="100" dirty="0">
                <a:solidFill>
                  <a:srgbClr val="FF0000"/>
                </a:solidFill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＞</a:t>
            </a:r>
            <a:r>
              <a:rPr lang="en-US" altLang="zh-CN" sz="2400" b="1" kern="100" dirty="0" err="1">
                <a:solidFill>
                  <a:srgbClr val="FF0000"/>
                </a:solidFill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SUVmean</a:t>
            </a:r>
            <a:r>
              <a:rPr lang="zh-CN" altLang="zh-CN" sz="2400" b="1" kern="100" dirty="0">
                <a:solidFill>
                  <a:srgbClr val="FF0000"/>
                </a:solidFill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＞</a:t>
            </a:r>
            <a:r>
              <a:rPr lang="en-US" altLang="zh-CN" sz="2400" b="1" kern="100" dirty="0">
                <a:solidFill>
                  <a:srgbClr val="FF0000"/>
                </a:solidFill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TLG</a:t>
            </a:r>
            <a:endParaRPr lang="zh-CN" altLang="zh-CN" sz="2400" b="1" kern="100" dirty="0">
              <a:solidFill>
                <a:srgbClr val="FF0000"/>
              </a:solidFill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2" name="Picture 1">
            <a:extLst>
              <a:ext uri="{FF2B5EF4-FFF2-40B4-BE49-F238E27FC236}">
                <a16:creationId xmlns:a16="http://schemas.microsoft.com/office/drawing/2014/main" id="{9E7B62F7-CC2F-48CE-A33A-AFD0AE7D586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250" y="4829559"/>
            <a:ext cx="3940150" cy="857590"/>
          </a:xfrm>
          <a:prstGeom prst="rect">
            <a:avLst/>
          </a:prstGeom>
        </p:spPr>
      </p:pic>
      <p:sp>
        <p:nvSpPr>
          <p:cNvPr id="13" name="TextBox 9">
            <a:extLst>
              <a:ext uri="{FF2B5EF4-FFF2-40B4-BE49-F238E27FC236}">
                <a16:creationId xmlns:a16="http://schemas.microsoft.com/office/drawing/2014/main" id="{AC1D4B2B-6DDC-4D40-ADDE-D2E8B78333B3}"/>
              </a:ext>
            </a:extLst>
          </p:cNvPr>
          <p:cNvSpPr txBox="1"/>
          <p:nvPr/>
        </p:nvSpPr>
        <p:spPr>
          <a:xfrm>
            <a:off x="244001" y="5316800"/>
            <a:ext cx="2478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Zhang Linhan </a:t>
            </a:r>
            <a:r>
              <a:rPr lang="en-US" dirty="0"/>
              <a:t>et al; 2021</a:t>
            </a:r>
          </a:p>
        </p:txBody>
      </p:sp>
    </p:spTree>
    <p:extLst>
      <p:ext uri="{BB962C8B-B14F-4D97-AF65-F5344CB8AC3E}">
        <p14:creationId xmlns:p14="http://schemas.microsoft.com/office/powerpoint/2010/main" val="29828465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2DA73E-5B88-4AD1-9E4F-308C335A64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0871" y="171238"/>
            <a:ext cx="8675370" cy="1109852"/>
          </a:xfrm>
        </p:spPr>
        <p:txBody>
          <a:bodyPr>
            <a:normAutofit/>
          </a:bodyPr>
          <a:lstStyle/>
          <a:p>
            <a:r>
              <a:rPr lang="en-US" altLang="zh-CN" sz="2800" b="1" kern="0" dirty="0">
                <a:effectLst/>
                <a:latin typeface="+mn-lt"/>
                <a:ea typeface="仿宋" panose="02010609060101010101" pitchFamily="49" charset="-122"/>
              </a:rPr>
              <a:t>The ability of </a:t>
            </a:r>
            <a:r>
              <a:rPr lang="en-US" altLang="zh-CN" sz="2800" b="1" dirty="0">
                <a:effectLst/>
                <a:latin typeface="+mn-lt"/>
                <a:ea typeface="宋体" panose="02010600030101010101" pitchFamily="2" charset="-122"/>
              </a:rPr>
              <a:t>a single </a:t>
            </a:r>
            <a:r>
              <a:rPr lang="en-US" altLang="zh-CN" sz="2800" b="1" kern="0" dirty="0">
                <a:effectLst/>
                <a:latin typeface="+mn-lt"/>
                <a:ea typeface="仿宋" panose="02010609060101010101" pitchFamily="49" charset="-122"/>
              </a:rPr>
              <a:t>texture features to distinguish the grade of clear cell carcinoma</a:t>
            </a:r>
            <a:endParaRPr lang="zh-CN" altLang="en-US" sz="2800" dirty="0">
              <a:latin typeface="+mn-lt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BAA36F3-BEE3-4F92-8F3C-FF54FE548C38}"/>
              </a:ext>
            </a:extLst>
          </p:cNvPr>
          <p:cNvSpPr txBox="1"/>
          <p:nvPr/>
        </p:nvSpPr>
        <p:spPr>
          <a:xfrm>
            <a:off x="182911" y="4829559"/>
            <a:ext cx="60590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000" i="1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Note. P</a:t>
            </a:r>
            <a:r>
              <a:rPr lang="en-US" altLang="zh-CN" sz="1000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  refers to the significance for ROC curves</a:t>
            </a:r>
            <a:r>
              <a:rPr lang="en-US" altLang="zh-CN" sz="1000" kern="100" dirty="0">
                <a:ea typeface="仿宋" panose="02010609060101010101" pitchFamily="49" charset="-122"/>
                <a:cs typeface="Times New Roman" panose="02020603050405020304" pitchFamily="18" charset="0"/>
              </a:rPr>
              <a:t>.</a:t>
            </a:r>
            <a:endParaRPr lang="zh-CN" altLang="zh-CN" sz="10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1" name="Picture 1">
            <a:extLst>
              <a:ext uri="{FF2B5EF4-FFF2-40B4-BE49-F238E27FC236}">
                <a16:creationId xmlns:a16="http://schemas.microsoft.com/office/drawing/2014/main" id="{A6C877F2-3D14-4E98-A402-34753AD3F06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250" y="4829559"/>
            <a:ext cx="3940150" cy="857590"/>
          </a:xfrm>
          <a:prstGeom prst="rect">
            <a:avLst/>
          </a:prstGeom>
        </p:spPr>
      </p:pic>
      <p:sp>
        <p:nvSpPr>
          <p:cNvPr id="12" name="TextBox 9">
            <a:extLst>
              <a:ext uri="{FF2B5EF4-FFF2-40B4-BE49-F238E27FC236}">
                <a16:creationId xmlns:a16="http://schemas.microsoft.com/office/drawing/2014/main" id="{BFCDFD51-453F-4D78-BC92-CDCCD37F6BCB}"/>
              </a:ext>
            </a:extLst>
          </p:cNvPr>
          <p:cNvSpPr txBox="1"/>
          <p:nvPr/>
        </p:nvSpPr>
        <p:spPr>
          <a:xfrm>
            <a:off x="240871" y="5317817"/>
            <a:ext cx="2478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Zhang Linhan </a:t>
            </a:r>
            <a:r>
              <a:rPr lang="en-US" dirty="0"/>
              <a:t>et al; 2021</a:t>
            </a:r>
          </a:p>
        </p:txBody>
      </p:sp>
      <p:graphicFrame>
        <p:nvGraphicFramePr>
          <p:cNvPr id="6" name="内容占位符 5">
            <a:extLst>
              <a:ext uri="{FF2B5EF4-FFF2-40B4-BE49-F238E27FC236}">
                <a16:creationId xmlns:a16="http://schemas.microsoft.com/office/drawing/2014/main" id="{869C06ED-CACE-4C1B-92BE-2DBF1558D34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02998797"/>
              </p:ext>
            </p:extLst>
          </p:nvPr>
        </p:nvGraphicFramePr>
        <p:xfrm>
          <a:off x="127591" y="1281090"/>
          <a:ext cx="6790794" cy="3534075"/>
        </p:xfrm>
        <a:graphic>
          <a:graphicData uri="http://schemas.openxmlformats.org/drawingml/2006/table">
            <a:tbl>
              <a:tblPr firstRow="1" firstCol="1" bandRow="1">
                <a:tableStyleId>{21E4AEA4-8DFA-4A89-87EB-49C32662AFE0}</a:tableStyleId>
              </a:tblPr>
              <a:tblGrid>
                <a:gridCol w="1950689">
                  <a:extLst>
                    <a:ext uri="{9D8B030D-6E8A-4147-A177-3AD203B41FA5}">
                      <a16:colId xmlns:a16="http://schemas.microsoft.com/office/drawing/2014/main" val="1975441575"/>
                    </a:ext>
                  </a:extLst>
                </a:gridCol>
                <a:gridCol w="1765005">
                  <a:extLst>
                    <a:ext uri="{9D8B030D-6E8A-4147-A177-3AD203B41FA5}">
                      <a16:colId xmlns:a16="http://schemas.microsoft.com/office/drawing/2014/main" val="2697085699"/>
                    </a:ext>
                  </a:extLst>
                </a:gridCol>
                <a:gridCol w="1756663">
                  <a:extLst>
                    <a:ext uri="{9D8B030D-6E8A-4147-A177-3AD203B41FA5}">
                      <a16:colId xmlns:a16="http://schemas.microsoft.com/office/drawing/2014/main" val="766752125"/>
                    </a:ext>
                  </a:extLst>
                </a:gridCol>
                <a:gridCol w="694660">
                  <a:extLst>
                    <a:ext uri="{9D8B030D-6E8A-4147-A177-3AD203B41FA5}">
                      <a16:colId xmlns:a16="http://schemas.microsoft.com/office/drawing/2014/main" val="2066503966"/>
                    </a:ext>
                  </a:extLst>
                </a:gridCol>
                <a:gridCol w="623777">
                  <a:extLst>
                    <a:ext uri="{9D8B030D-6E8A-4147-A177-3AD203B41FA5}">
                      <a16:colId xmlns:a16="http://schemas.microsoft.com/office/drawing/2014/main" val="2974967711"/>
                    </a:ext>
                  </a:extLst>
                </a:gridCol>
              </a:tblGrid>
              <a:tr h="247906">
                <a:tc>
                  <a:txBody>
                    <a:bodyPr/>
                    <a:lstStyle/>
                    <a:p>
                      <a:pPr algn="l"/>
                      <a:r>
                        <a:rPr lang="en-US" sz="1200" kern="0" dirty="0">
                          <a:effectLst/>
                          <a:latin typeface="+mn-lt"/>
                        </a:rPr>
                        <a:t>Texture parameter</a:t>
                      </a:r>
                      <a:endParaRPr lang="zh-CN" sz="12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indent="95250" algn="ctr"/>
                      <a:r>
                        <a:rPr lang="en-US" sz="1200" kern="0">
                          <a:effectLst/>
                        </a:rPr>
                        <a:t>Low grade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N=27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indent="95250" algn="ctr"/>
                      <a:r>
                        <a:rPr lang="en-US" sz="1200" kern="0">
                          <a:effectLst/>
                        </a:rPr>
                        <a:t>High grade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N=22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AUC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P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2921359040"/>
                  </a:ext>
                </a:extLst>
              </a:tr>
              <a:tr h="255181">
                <a:tc>
                  <a:txBody>
                    <a:bodyPr/>
                    <a:lstStyle/>
                    <a:p>
                      <a:pPr algn="l"/>
                      <a:r>
                        <a:rPr lang="en-US" sz="1200" kern="0" dirty="0">
                          <a:effectLst/>
                          <a:latin typeface="+mn-lt"/>
                        </a:rPr>
                        <a:t>HISTO_Entropy_log10</a:t>
                      </a:r>
                      <a:r>
                        <a:rPr lang="zh-CN" sz="1200" kern="0" dirty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 dirty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 dirty="0">
                          <a:effectLst/>
                          <a:latin typeface="+mn-lt"/>
                        </a:rPr>
                        <a:t>）</a:t>
                      </a:r>
                      <a:endParaRPr lang="zh-CN" sz="12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77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0.69~0.79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89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0.76~0.99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746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3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4125392269"/>
                  </a:ext>
                </a:extLst>
              </a:tr>
              <a:tr h="226828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HISTO_Entropy_log2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2.57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2.29~2.64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2.96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2.52~3.28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746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3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1522390401"/>
                  </a:ext>
                </a:extLst>
              </a:tr>
              <a:tr h="141768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CM_Contras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1.53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1.24~1.8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2.39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1.41~3.92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746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003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2251384510"/>
                  </a:ext>
                </a:extLst>
              </a:tr>
              <a:tr h="194930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CM_Entropy_log10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1.38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1.19~1.43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1.59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1.37~1.79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746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003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145527631"/>
                  </a:ext>
                </a:extLst>
              </a:tr>
              <a:tr h="170121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CM_Entropy_log2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4.57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3.96~4.76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5.27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4.54~5.93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746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003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3931627755"/>
                  </a:ext>
                </a:extLst>
              </a:tr>
              <a:tr h="134679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CM_Dissimilarity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9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0.79~1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1.15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0.87~1.51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747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3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2368315398"/>
                  </a:ext>
                </a:extLst>
              </a:tr>
              <a:tr h="202019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RLM_HGRE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41.15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28.19~56.18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67.96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51.61~106.44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790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1971487995"/>
                  </a:ext>
                </a:extLst>
              </a:tr>
              <a:tr h="155944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RLM_SRHGE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31.48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23.26~46.33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57.08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41.82~92.72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786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2902964511"/>
                  </a:ext>
                </a:extLst>
              </a:tr>
              <a:tr h="155944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RLM_LRHGE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106.89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67.99~129.83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151.38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104.74~195.83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739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4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357917605"/>
                  </a:ext>
                </a:extLst>
              </a:tr>
              <a:tr h="77972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ZLM_HGZE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52.9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39.2~64.27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92.44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60.56~124.45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811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372315889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ZLM_SZHGE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20.04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14.38~24.74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37.58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24.86~60.17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768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00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3397684383"/>
                  </a:ext>
                </a:extLst>
              </a:tr>
              <a:tr h="212651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ZLM_GLNU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3.74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2.65~7.37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9.47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2.26~13.88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666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048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3953958163"/>
                  </a:ext>
                </a:extLst>
              </a:tr>
              <a:tr h="113414">
                <a:tc>
                  <a:txBody>
                    <a:bodyPr/>
                    <a:lstStyle/>
                    <a:p>
                      <a:pPr algn="l"/>
                      <a:r>
                        <a:rPr lang="en-US" sz="1200" kern="0">
                          <a:effectLst/>
                          <a:latin typeface="+mn-lt"/>
                        </a:rPr>
                        <a:t>GLZLM_ZLNU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0">
                          <a:effectLst/>
                          <a:latin typeface="+mn-lt"/>
                        </a:rPr>
                        <a:t>PET</a:t>
                      </a:r>
                      <a:r>
                        <a:rPr lang="zh-CN" sz="1200" kern="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4.88</a:t>
                      </a:r>
                      <a:r>
                        <a:rPr lang="zh-CN" sz="1200" kern="0">
                          <a:effectLst/>
                        </a:rPr>
                        <a:t>（</a:t>
                      </a:r>
                      <a:r>
                        <a:rPr lang="en-US" sz="1200" kern="0">
                          <a:effectLst/>
                        </a:rPr>
                        <a:t>2.4~6.35</a:t>
                      </a:r>
                      <a:r>
                        <a:rPr lang="zh-CN" sz="1200" kern="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14.56</a:t>
                      </a:r>
                      <a:r>
                        <a:rPr lang="zh-CN" sz="1200" kern="0" dirty="0">
                          <a:effectLst/>
                        </a:rPr>
                        <a:t>（</a:t>
                      </a:r>
                      <a:r>
                        <a:rPr lang="en-US" sz="1200" kern="0" dirty="0">
                          <a:effectLst/>
                        </a:rPr>
                        <a:t>5.08~36.88</a:t>
                      </a:r>
                      <a:r>
                        <a:rPr lang="zh-CN" sz="1200" kern="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 dirty="0">
                          <a:effectLst/>
                        </a:rPr>
                        <a:t>0.719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0">
                          <a:effectLst/>
                        </a:rPr>
                        <a:t>0.009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3330489672"/>
                  </a:ext>
                </a:extLst>
              </a:tr>
              <a:tr h="180754">
                <a:tc>
                  <a:txBody>
                    <a:bodyPr/>
                    <a:lstStyle/>
                    <a:p>
                      <a:pPr algn="l"/>
                      <a:r>
                        <a:rPr lang="en-US" sz="1200" kern="100">
                          <a:effectLst/>
                          <a:latin typeface="+mn-lt"/>
                        </a:rPr>
                        <a:t>GLRLM_HGRE</a:t>
                      </a:r>
                      <a:r>
                        <a:rPr lang="zh-CN" sz="1200" kern="100">
                          <a:effectLst/>
                          <a:latin typeface="+mn-lt"/>
                        </a:rPr>
                        <a:t>（</a:t>
                      </a:r>
                      <a:r>
                        <a:rPr lang="en-US" sz="1200" kern="100">
                          <a:effectLst/>
                          <a:latin typeface="+mn-lt"/>
                        </a:rPr>
                        <a:t>CT</a:t>
                      </a:r>
                      <a:r>
                        <a:rPr lang="zh-CN" sz="1200" kern="100">
                          <a:effectLst/>
                          <a:latin typeface="+mn-lt"/>
                        </a:rPr>
                        <a:t>）</a:t>
                      </a:r>
                      <a:endParaRPr lang="zh-CN" sz="1200" kern="10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</a:rPr>
                        <a:t>10548.84</a:t>
                      </a:r>
                      <a:r>
                        <a:rPr lang="zh-CN" sz="1200" kern="100">
                          <a:effectLst/>
                        </a:rPr>
                        <a:t>（</a:t>
                      </a:r>
                      <a:r>
                        <a:rPr lang="en-US" sz="1200" kern="100">
                          <a:effectLst/>
                        </a:rPr>
                        <a:t>10501.66~10634.58</a:t>
                      </a:r>
                      <a:r>
                        <a:rPr lang="zh-CN" sz="1200" kern="10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0737.51</a:t>
                      </a:r>
                      <a:r>
                        <a:rPr lang="zh-CN" sz="1200" kern="100" dirty="0">
                          <a:effectLst/>
                        </a:rPr>
                        <a:t>（</a:t>
                      </a:r>
                      <a:r>
                        <a:rPr lang="en-US" sz="1200" kern="100" dirty="0">
                          <a:effectLst/>
                        </a:rPr>
                        <a:t>10661.28~10794.27</a:t>
                      </a:r>
                      <a:r>
                        <a:rPr lang="zh-CN" sz="1200" kern="10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0.879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0.00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1448759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  <a:latin typeface="+mn-lt"/>
                        </a:rPr>
                        <a:t>GLZLM_HGZE(CT)</a:t>
                      </a:r>
                      <a:endParaRPr lang="zh-CN" sz="1200" kern="100" dirty="0">
                        <a:effectLst/>
                        <a:latin typeface="+mn-lt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0275.65</a:t>
                      </a:r>
                      <a:r>
                        <a:rPr lang="zh-CN" sz="1200" kern="100" dirty="0">
                          <a:effectLst/>
                        </a:rPr>
                        <a:t>（</a:t>
                      </a:r>
                      <a:r>
                        <a:rPr lang="en-US" sz="1200" kern="100" dirty="0">
                          <a:effectLst/>
                        </a:rPr>
                        <a:t>10103.23~10413.19337</a:t>
                      </a:r>
                      <a:r>
                        <a:rPr lang="zh-CN" sz="1200" kern="10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0504.91</a:t>
                      </a:r>
                      <a:r>
                        <a:rPr lang="zh-CN" sz="1200" kern="100" dirty="0">
                          <a:effectLst/>
                        </a:rPr>
                        <a:t>（</a:t>
                      </a:r>
                      <a:r>
                        <a:rPr lang="en-US" sz="1200" kern="100" dirty="0">
                          <a:effectLst/>
                        </a:rPr>
                        <a:t>10361.19~10566.41</a:t>
                      </a:r>
                      <a:r>
                        <a:rPr lang="zh-CN" sz="1200" kern="10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0.857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0.00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312" marR="68312" marT="0" marB="0" anchor="ctr"/>
                </a:tc>
                <a:extLst>
                  <a:ext uri="{0D108BD9-81ED-4DB2-BD59-A6C34878D82A}">
                    <a16:rowId xmlns:a16="http://schemas.microsoft.com/office/drawing/2014/main" val="1084271397"/>
                  </a:ext>
                </a:extLst>
              </a:tr>
            </a:tbl>
          </a:graphicData>
        </a:graphic>
      </p:graphicFrame>
      <p:sp>
        <p:nvSpPr>
          <p:cNvPr id="14" name="文本框 13">
            <a:extLst>
              <a:ext uri="{FF2B5EF4-FFF2-40B4-BE49-F238E27FC236}">
                <a16:creationId xmlns:a16="http://schemas.microsoft.com/office/drawing/2014/main" id="{6483B9D5-25A0-4B82-9F50-835A9BF53732}"/>
              </a:ext>
            </a:extLst>
          </p:cNvPr>
          <p:cNvSpPr txBox="1"/>
          <p:nvPr/>
        </p:nvSpPr>
        <p:spPr>
          <a:xfrm>
            <a:off x="6918385" y="1266696"/>
            <a:ext cx="2984330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dist"/>
            <a:r>
              <a:rPr lang="en-US" altLang="zh-CN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Among the 42 PET texture features, there were 2 in HISTO features, 4 in GLCM features, 3 in GLRLM features and 4 in GLZLM features that had good discriminative ability and diagnostic performance. Among CT texture features, 1 in GLRLM feature and 1 in GLZLM feature had good discriminating ability.</a:t>
            </a:r>
            <a:endParaRPr lang="zh-CN" altLang="zh-CN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74355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BF224B-502B-4A0E-83CF-D9F6172D8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4186" y="263927"/>
            <a:ext cx="8950026" cy="1109852"/>
          </a:xfrm>
        </p:spPr>
        <p:txBody>
          <a:bodyPr>
            <a:noAutofit/>
          </a:bodyPr>
          <a:lstStyle/>
          <a:p>
            <a:r>
              <a:rPr lang="en-US" altLang="zh-CN" sz="2800" b="1" dirty="0">
                <a:effectLst/>
                <a:latin typeface="+mn-lt"/>
                <a:ea typeface="宋体" panose="02010600030101010101" pitchFamily="2" charset="-122"/>
              </a:rPr>
              <a:t>Comparison of the difference in diagnostic ability between the radiomic variable prediction models and the SUV models</a:t>
            </a:r>
            <a:endParaRPr lang="zh-CN" altLang="en-US" sz="2800" dirty="0">
              <a:latin typeface="+mn-lt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6E492DCA-3927-41E8-BB5E-3F8CF2AC78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6807241"/>
              </p:ext>
            </p:extLst>
          </p:nvPr>
        </p:nvGraphicFramePr>
        <p:xfrm>
          <a:off x="315965" y="1641889"/>
          <a:ext cx="9426469" cy="2887582"/>
        </p:xfrm>
        <a:graphic>
          <a:graphicData uri="http://schemas.openxmlformats.org/drawingml/2006/table">
            <a:tbl>
              <a:tblPr firstRow="1" firstCol="1" bandRow="1">
                <a:tableStyleId>{93296810-A885-4BE3-A3E7-6D5BEEA58F35}</a:tableStyleId>
              </a:tblPr>
              <a:tblGrid>
                <a:gridCol w="2251681">
                  <a:extLst>
                    <a:ext uri="{9D8B030D-6E8A-4147-A177-3AD203B41FA5}">
                      <a16:colId xmlns:a16="http://schemas.microsoft.com/office/drawing/2014/main" val="1529333018"/>
                    </a:ext>
                  </a:extLst>
                </a:gridCol>
                <a:gridCol w="1034903">
                  <a:extLst>
                    <a:ext uri="{9D8B030D-6E8A-4147-A177-3AD203B41FA5}">
                      <a16:colId xmlns:a16="http://schemas.microsoft.com/office/drawing/2014/main" val="892885365"/>
                    </a:ext>
                  </a:extLst>
                </a:gridCol>
                <a:gridCol w="1112874">
                  <a:extLst>
                    <a:ext uri="{9D8B030D-6E8A-4147-A177-3AD203B41FA5}">
                      <a16:colId xmlns:a16="http://schemas.microsoft.com/office/drawing/2014/main" val="2673979521"/>
                    </a:ext>
                  </a:extLst>
                </a:gridCol>
                <a:gridCol w="1070344">
                  <a:extLst>
                    <a:ext uri="{9D8B030D-6E8A-4147-A177-3AD203B41FA5}">
                      <a16:colId xmlns:a16="http://schemas.microsoft.com/office/drawing/2014/main" val="784062516"/>
                    </a:ext>
                  </a:extLst>
                </a:gridCol>
                <a:gridCol w="1112875">
                  <a:extLst>
                    <a:ext uri="{9D8B030D-6E8A-4147-A177-3AD203B41FA5}">
                      <a16:colId xmlns:a16="http://schemas.microsoft.com/office/drawing/2014/main" val="35214091"/>
                    </a:ext>
                  </a:extLst>
                </a:gridCol>
                <a:gridCol w="1020725">
                  <a:extLst>
                    <a:ext uri="{9D8B030D-6E8A-4147-A177-3AD203B41FA5}">
                      <a16:colId xmlns:a16="http://schemas.microsoft.com/office/drawing/2014/main" val="1779745395"/>
                    </a:ext>
                  </a:extLst>
                </a:gridCol>
                <a:gridCol w="793898">
                  <a:extLst>
                    <a:ext uri="{9D8B030D-6E8A-4147-A177-3AD203B41FA5}">
                      <a16:colId xmlns:a16="http://schemas.microsoft.com/office/drawing/2014/main" val="956164169"/>
                    </a:ext>
                  </a:extLst>
                </a:gridCol>
                <a:gridCol w="1029169">
                  <a:extLst>
                    <a:ext uri="{9D8B030D-6E8A-4147-A177-3AD203B41FA5}">
                      <a16:colId xmlns:a16="http://schemas.microsoft.com/office/drawing/2014/main" val="3364559933"/>
                    </a:ext>
                  </a:extLst>
                </a:gridCol>
              </a:tblGrid>
              <a:tr h="597287">
                <a:tc>
                  <a:txBody>
                    <a:bodyPr/>
                    <a:lstStyle/>
                    <a:p>
                      <a:pPr algn="ctr"/>
                      <a:r>
                        <a:rPr lang="zh-CN" sz="1400" kern="0" dirty="0">
                          <a:effectLst/>
                        </a:rPr>
                        <a:t>　</a:t>
                      </a:r>
                      <a:r>
                        <a:rPr lang="en-US" sz="1400" kern="0" dirty="0">
                          <a:effectLst/>
                        </a:rPr>
                        <a:t> model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cut-off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Sensitivity</a:t>
                      </a:r>
                    </a:p>
                    <a:p>
                      <a:pPr algn="ctr"/>
                      <a:r>
                        <a:rPr lang="en-US" sz="1400" kern="0" dirty="0">
                          <a:effectLst/>
                        </a:rPr>
                        <a:t>(%)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Specificity</a:t>
                      </a:r>
                    </a:p>
                    <a:p>
                      <a:pPr algn="ctr"/>
                      <a:r>
                        <a:rPr lang="en-US" sz="1400" kern="0" dirty="0">
                          <a:effectLst/>
                        </a:rPr>
                        <a:t>(%)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PPV</a:t>
                      </a:r>
                    </a:p>
                    <a:p>
                      <a:pPr algn="ctr"/>
                      <a:r>
                        <a:rPr lang="en-US" sz="1400" kern="0" dirty="0">
                          <a:effectLst/>
                        </a:rPr>
                        <a:t>(%)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NPV</a:t>
                      </a:r>
                    </a:p>
                    <a:p>
                      <a:pPr algn="ctr"/>
                      <a:r>
                        <a:rPr lang="en-US" sz="1400" kern="0" dirty="0">
                          <a:effectLst/>
                        </a:rPr>
                        <a:t>(%)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effectLst/>
                        </a:rPr>
                        <a:t>AUC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P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18627187"/>
                  </a:ext>
                </a:extLst>
              </a:tr>
              <a:tr h="490778"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 err="1">
                          <a:effectLst/>
                        </a:rPr>
                        <a:t>SUVmax</a:t>
                      </a:r>
                      <a:r>
                        <a:rPr lang="en-US" sz="1400" kern="0" dirty="0">
                          <a:effectLst/>
                        </a:rPr>
                        <a:t> model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&gt;4.11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68.18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solidFill>
                            <a:schemeClr val="bg1"/>
                          </a:solidFill>
                          <a:effectLst/>
                        </a:rPr>
                        <a:t>88.89</a:t>
                      </a:r>
                      <a:endParaRPr lang="zh-CN" sz="1400" kern="10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solidFill>
                            <a:schemeClr val="bg1"/>
                          </a:solidFill>
                          <a:effectLst/>
                        </a:rPr>
                        <a:t>71.4</a:t>
                      </a:r>
                      <a:endParaRPr lang="zh-CN" sz="1400" kern="10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solidFill>
                            <a:schemeClr val="bg1"/>
                          </a:solidFill>
                          <a:effectLst/>
                        </a:rPr>
                        <a:t>75</a:t>
                      </a:r>
                      <a:endParaRPr lang="zh-CN" sz="1400" kern="10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0.803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effectLst/>
                        </a:rPr>
                        <a:t>&lt;0.0001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38884687"/>
                  </a:ext>
                </a:extLst>
              </a:tr>
              <a:tr h="490778"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SUL model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&gt;1.91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59.09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96.3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92.9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solidFill>
                            <a:schemeClr val="bg1"/>
                          </a:solidFill>
                          <a:effectLst/>
                        </a:rPr>
                        <a:t>74.3</a:t>
                      </a:r>
                      <a:endParaRPr lang="zh-CN" sz="1400" kern="10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solidFill>
                            <a:schemeClr val="bg1"/>
                          </a:solidFill>
                          <a:effectLst/>
                        </a:rPr>
                        <a:t>0.819</a:t>
                      </a:r>
                      <a:endParaRPr lang="zh-CN" sz="1400" kern="10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effectLst/>
                        </a:rPr>
                        <a:t>&lt;0.0001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17934340"/>
                  </a:ext>
                </a:extLst>
              </a:tr>
              <a:tr h="490778"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effectLst/>
                        </a:rPr>
                        <a:t>PET texture parameter model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effectLst/>
                        </a:rPr>
                        <a:t>&gt;-0.45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solidFill>
                            <a:schemeClr val="bg1"/>
                          </a:solidFill>
                          <a:effectLst/>
                        </a:rPr>
                        <a:t>81.82</a:t>
                      </a:r>
                      <a:endParaRPr lang="zh-CN" sz="1400" kern="10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88.89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88.2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78.1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0.873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effectLst/>
                        </a:rPr>
                        <a:t>&lt;0.0001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65454117"/>
                  </a:ext>
                </a:extLst>
              </a:tr>
              <a:tr h="817961"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PET/CT texture parameter model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>
                          <a:effectLst/>
                        </a:rPr>
                        <a:t>&gt;-87.1</a:t>
                      </a:r>
                      <a:endParaRPr lang="zh-CN" sz="1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86.36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88.89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86.4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88.9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solidFill>
                            <a:schemeClr val="bg1"/>
                          </a:solidFill>
                          <a:effectLst/>
                        </a:rPr>
                        <a:t>0.926</a:t>
                      </a:r>
                      <a:endParaRPr lang="zh-CN" sz="1400" kern="100" dirty="0">
                        <a:solidFill>
                          <a:schemeClr val="bg1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0" dirty="0">
                          <a:effectLst/>
                        </a:rPr>
                        <a:t>&lt;0.0001</a:t>
                      </a:r>
                      <a:endParaRPr lang="zh-CN" sz="1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50888512"/>
                  </a:ext>
                </a:extLst>
              </a:tr>
            </a:tbl>
          </a:graphicData>
        </a:graphic>
      </p:graphicFrame>
      <p:pic>
        <p:nvPicPr>
          <p:cNvPr id="8" name="Picture 1">
            <a:extLst>
              <a:ext uri="{FF2B5EF4-FFF2-40B4-BE49-F238E27FC236}">
                <a16:creationId xmlns:a16="http://schemas.microsoft.com/office/drawing/2014/main" id="{EA695C9E-774B-4C88-ABF6-23C1D7D8A4E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250" y="4829559"/>
            <a:ext cx="3940150" cy="857590"/>
          </a:xfrm>
          <a:prstGeom prst="rect">
            <a:avLst/>
          </a:prstGeom>
        </p:spPr>
      </p:pic>
      <p:sp>
        <p:nvSpPr>
          <p:cNvPr id="9" name="TextBox 9">
            <a:extLst>
              <a:ext uri="{FF2B5EF4-FFF2-40B4-BE49-F238E27FC236}">
                <a16:creationId xmlns:a16="http://schemas.microsoft.com/office/drawing/2014/main" id="{14159DAD-28DF-43B1-A5EC-F1BB706BA929}"/>
              </a:ext>
            </a:extLst>
          </p:cNvPr>
          <p:cNvSpPr txBox="1"/>
          <p:nvPr/>
        </p:nvSpPr>
        <p:spPr>
          <a:xfrm>
            <a:off x="244001" y="5316800"/>
            <a:ext cx="2478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Zhang Linhan </a:t>
            </a:r>
            <a:r>
              <a:rPr lang="en-US" dirty="0"/>
              <a:t>et al; 2021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3C16E7C-E3D8-4399-A6B0-E6821BA21CFB}"/>
              </a:ext>
            </a:extLst>
          </p:cNvPr>
          <p:cNvSpPr txBox="1"/>
          <p:nvPr/>
        </p:nvSpPr>
        <p:spPr>
          <a:xfrm>
            <a:off x="315965" y="4676914"/>
            <a:ext cx="60590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Note. P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  refers to the </a:t>
            </a:r>
            <a:r>
              <a:rPr lang="en-US" altLang="zh-CN" sz="1000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significance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 for ROC curves</a:t>
            </a:r>
            <a:r>
              <a:rPr lang="en-US" altLang="zh-CN" sz="1000" kern="100" dirty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.</a:t>
            </a:r>
            <a:endParaRPr lang="zh-CN" altLang="zh-CN" sz="10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06287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9070CF3E-3613-4DDD-B43A-AED82418DB5E}"/>
              </a:ext>
            </a:extLst>
          </p:cNvPr>
          <p:cNvSpPr txBox="1"/>
          <p:nvPr/>
        </p:nvSpPr>
        <p:spPr>
          <a:xfrm>
            <a:off x="362099" y="50774"/>
            <a:ext cx="9334201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b="1" dirty="0">
                <a:effectLst/>
                <a:ea typeface="宋体" panose="02010600030101010101" pitchFamily="2" charset="-122"/>
              </a:rPr>
              <a:t>ROC graphs of SUV model and texture parameter model in predicting the ability to </a:t>
            </a:r>
            <a:r>
              <a:rPr lang="en-US" altLang="zh-CN" sz="2800" b="1" dirty="0" err="1">
                <a:effectLst/>
                <a:ea typeface="宋体" panose="02010600030101010101" pitchFamily="2" charset="-122"/>
              </a:rPr>
              <a:t>ccRCC</a:t>
            </a:r>
            <a:r>
              <a:rPr lang="en-US" altLang="zh-CN" sz="2800" b="1" dirty="0">
                <a:effectLst/>
                <a:ea typeface="宋体" panose="02010600030101010101" pitchFamily="2" charset="-122"/>
              </a:rPr>
              <a:t> Fuhrman nuclear grade</a:t>
            </a:r>
            <a:endParaRPr lang="zh-CN" altLang="en-US" sz="2800" dirty="0"/>
          </a:p>
        </p:txBody>
      </p:sp>
      <p:pic>
        <p:nvPicPr>
          <p:cNvPr id="19" name="Picture 1">
            <a:extLst>
              <a:ext uri="{FF2B5EF4-FFF2-40B4-BE49-F238E27FC236}">
                <a16:creationId xmlns:a16="http://schemas.microsoft.com/office/drawing/2014/main" id="{A278DDC6-356D-408E-BCFD-64995317119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250" y="4798182"/>
            <a:ext cx="3940150" cy="857590"/>
          </a:xfrm>
          <a:prstGeom prst="rect">
            <a:avLst/>
          </a:prstGeom>
        </p:spPr>
      </p:pic>
      <p:sp>
        <p:nvSpPr>
          <p:cNvPr id="20" name="TextBox 9">
            <a:extLst>
              <a:ext uri="{FF2B5EF4-FFF2-40B4-BE49-F238E27FC236}">
                <a16:creationId xmlns:a16="http://schemas.microsoft.com/office/drawing/2014/main" id="{DA3918AA-8842-4BBB-AA1F-CEFF201A2276}"/>
              </a:ext>
            </a:extLst>
          </p:cNvPr>
          <p:cNvSpPr txBox="1"/>
          <p:nvPr/>
        </p:nvSpPr>
        <p:spPr>
          <a:xfrm>
            <a:off x="244001" y="5316800"/>
            <a:ext cx="24340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Zhang </a:t>
            </a:r>
            <a:r>
              <a:rPr lang="en-US" altLang="zh-CN" dirty="0" err="1"/>
              <a:t>linhan</a:t>
            </a:r>
            <a:r>
              <a:rPr lang="en-US" altLang="zh-CN" dirty="0"/>
              <a:t> </a:t>
            </a:r>
            <a:r>
              <a:rPr lang="en-US" dirty="0"/>
              <a:t>et al; 2021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4980FAB2-2BA0-4144-A27E-4C8B5094973E}"/>
              </a:ext>
            </a:extLst>
          </p:cNvPr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244001" y="1124579"/>
            <a:ext cx="2179768" cy="242145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647862D-2441-4546-82B2-094A34CDB735}"/>
              </a:ext>
            </a:extLst>
          </p:cNvPr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2595423" y="1124579"/>
            <a:ext cx="2320963" cy="2421451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6CC23F9-13C7-44DF-940A-AB061638CE33}"/>
              </a:ext>
            </a:extLst>
          </p:cNvPr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5142016" y="1108398"/>
            <a:ext cx="2273897" cy="242145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8D6CFDA-6C60-4A94-841A-EF678D5E4F17}"/>
              </a:ext>
            </a:extLst>
          </p:cNvPr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7656146" y="1099654"/>
            <a:ext cx="2158253" cy="2421451"/>
          </a:xfrm>
          <a:prstGeom prst="rect">
            <a:avLst/>
          </a:prstGeom>
        </p:spPr>
      </p:pic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2EF5D978-0E00-4648-84D3-B215EED618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2261260"/>
              </p:ext>
            </p:extLst>
          </p:nvPr>
        </p:nvGraphicFramePr>
        <p:xfrm>
          <a:off x="133292" y="3882858"/>
          <a:ext cx="5225377" cy="12344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614928">
                  <a:extLst>
                    <a:ext uri="{9D8B030D-6E8A-4147-A177-3AD203B41FA5}">
                      <a16:colId xmlns:a16="http://schemas.microsoft.com/office/drawing/2014/main" val="1561127110"/>
                    </a:ext>
                  </a:extLst>
                </a:gridCol>
                <a:gridCol w="610449">
                  <a:extLst>
                    <a:ext uri="{9D8B030D-6E8A-4147-A177-3AD203B41FA5}">
                      <a16:colId xmlns:a16="http://schemas.microsoft.com/office/drawing/2014/main" val="2948844612"/>
                    </a:ext>
                  </a:extLst>
                </a:gridCol>
              </a:tblGrid>
              <a:tr h="80010"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>
                          <a:effectLst/>
                        </a:rPr>
                        <a:t>model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>
                          <a:effectLst/>
                        </a:rPr>
                        <a:t>P value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30077244"/>
                  </a:ext>
                </a:extLst>
              </a:tr>
              <a:tr h="92075">
                <a:tc>
                  <a:txBody>
                    <a:bodyPr/>
                    <a:lstStyle/>
                    <a:p>
                      <a:pPr algn="just"/>
                      <a:r>
                        <a:rPr lang="en-US" sz="1050" kern="0" dirty="0" err="1">
                          <a:effectLst/>
                        </a:rPr>
                        <a:t>SUVmax</a:t>
                      </a:r>
                      <a:r>
                        <a:rPr lang="en-US" sz="1050" kern="0" dirty="0">
                          <a:effectLst/>
                        </a:rPr>
                        <a:t> model VS SUL model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>
                          <a:effectLst/>
                        </a:rPr>
                        <a:t>0.725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92721604"/>
                  </a:ext>
                </a:extLst>
              </a:tr>
              <a:tr h="189865">
                <a:tc>
                  <a:txBody>
                    <a:bodyPr/>
                    <a:lstStyle/>
                    <a:p>
                      <a:pPr algn="just"/>
                      <a:r>
                        <a:rPr lang="en-US" sz="1050" kern="0" dirty="0">
                          <a:effectLst/>
                        </a:rPr>
                        <a:t>PET texture parameter model VS PET/CT texture parameter model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>
                          <a:effectLst/>
                        </a:rPr>
                        <a:t>0.171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90626187"/>
                  </a:ext>
                </a:extLst>
              </a:tr>
              <a:tr h="92075">
                <a:tc>
                  <a:txBody>
                    <a:bodyPr/>
                    <a:lstStyle/>
                    <a:p>
                      <a:pPr algn="just"/>
                      <a:r>
                        <a:rPr lang="en-US" sz="1050" kern="0" dirty="0">
                          <a:effectLst/>
                        </a:rPr>
                        <a:t>PET/CT texture parameter model VS SUL model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>
                          <a:effectLst/>
                        </a:rPr>
                        <a:t>0.0529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97611011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just"/>
                      <a:r>
                        <a:rPr lang="en-US" sz="1050" kern="0">
                          <a:effectLst/>
                        </a:rPr>
                        <a:t>SUVmax model VS PET/CT texture parameter model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>
                          <a:effectLst/>
                        </a:rPr>
                        <a:t>0.02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61481015"/>
                  </a:ext>
                </a:extLst>
              </a:tr>
              <a:tr h="189865">
                <a:tc>
                  <a:txBody>
                    <a:bodyPr/>
                    <a:lstStyle/>
                    <a:p>
                      <a:pPr algn="just"/>
                      <a:r>
                        <a:rPr lang="en-US" sz="1050" kern="0" dirty="0">
                          <a:effectLst/>
                        </a:rPr>
                        <a:t>SUL model VS PET texture parameter model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>
                          <a:effectLst/>
                        </a:rPr>
                        <a:t>0.2691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37200474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just"/>
                      <a:r>
                        <a:rPr lang="en-US" sz="1050" kern="0" dirty="0" err="1">
                          <a:effectLst/>
                        </a:rPr>
                        <a:t>SUVmax</a:t>
                      </a:r>
                      <a:r>
                        <a:rPr lang="en-US" sz="1050" kern="0" dirty="0">
                          <a:effectLst/>
                        </a:rPr>
                        <a:t> model VS PET texture parameter model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050" kern="100" dirty="0">
                          <a:effectLst/>
                        </a:rPr>
                        <a:t>0.017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71017838"/>
                  </a:ext>
                </a:extLst>
              </a:tr>
            </a:tbl>
          </a:graphicData>
        </a:graphic>
      </p:graphicFrame>
      <p:sp>
        <p:nvSpPr>
          <p:cNvPr id="16" name="文本框 15">
            <a:extLst>
              <a:ext uri="{FF2B5EF4-FFF2-40B4-BE49-F238E27FC236}">
                <a16:creationId xmlns:a16="http://schemas.microsoft.com/office/drawing/2014/main" id="{6F3F3884-B54E-4AF4-B366-0A43F7D693F6}"/>
              </a:ext>
            </a:extLst>
          </p:cNvPr>
          <p:cNvSpPr txBox="1"/>
          <p:nvPr/>
        </p:nvSpPr>
        <p:spPr>
          <a:xfrm>
            <a:off x="407675" y="3591322"/>
            <a:ext cx="1959842" cy="2745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effectLst/>
                <a:ea typeface="宋体" panose="02010600030101010101" pitchFamily="2" charset="-122"/>
              </a:rPr>
              <a:t>A: </a:t>
            </a:r>
            <a:r>
              <a:rPr lang="en-US" altLang="zh-CN" sz="1200" b="1" kern="100" dirty="0" err="1">
                <a:effectLst/>
                <a:ea typeface="宋体" panose="02010600030101010101" pitchFamily="2" charset="-122"/>
              </a:rPr>
              <a:t>SUVmax</a:t>
            </a:r>
            <a:r>
              <a:rPr lang="en-US" altLang="zh-CN" sz="1200" b="1" kern="100" dirty="0">
                <a:effectLst/>
                <a:ea typeface="宋体" panose="02010600030101010101" pitchFamily="2" charset="-122"/>
              </a:rPr>
              <a:t> model</a:t>
            </a:r>
            <a:endParaRPr lang="zh-CN" altLang="en-US" sz="12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1FC5535-C269-4265-8A11-71F0B5E54284}"/>
              </a:ext>
            </a:extLst>
          </p:cNvPr>
          <p:cNvSpPr txBox="1"/>
          <p:nvPr/>
        </p:nvSpPr>
        <p:spPr>
          <a:xfrm>
            <a:off x="7538512" y="3557217"/>
            <a:ext cx="258654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effectLst/>
                <a:ea typeface="宋体" panose="02010600030101010101" pitchFamily="2" charset="-122"/>
              </a:rPr>
              <a:t>D:</a:t>
            </a:r>
            <a:r>
              <a:rPr lang="en-US" altLang="zh-CN" sz="1200" b="1" dirty="0">
                <a:effectLst/>
                <a:ea typeface="仿宋" panose="02010609060101010101" pitchFamily="49" charset="-122"/>
              </a:rPr>
              <a:t> PET/CT texture parameter model</a:t>
            </a:r>
            <a:endParaRPr lang="zh-CN" altLang="en-US" sz="12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FE66FF5-BCCD-4E7E-842D-8E46C278A1E7}"/>
              </a:ext>
            </a:extLst>
          </p:cNvPr>
          <p:cNvSpPr txBox="1"/>
          <p:nvPr/>
        </p:nvSpPr>
        <p:spPr>
          <a:xfrm>
            <a:off x="5149458" y="3591322"/>
            <a:ext cx="23760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effectLst/>
                <a:ea typeface="宋体" panose="02010600030101010101" pitchFamily="2" charset="-122"/>
              </a:rPr>
              <a:t>C:PET texture parameter model</a:t>
            </a:r>
            <a:endParaRPr lang="zh-CN" altLang="en-US" sz="12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AD8AFD1-E90D-4B0F-920A-0259C08E06E6}"/>
              </a:ext>
            </a:extLst>
          </p:cNvPr>
          <p:cNvSpPr txBox="1"/>
          <p:nvPr/>
        </p:nvSpPr>
        <p:spPr>
          <a:xfrm>
            <a:off x="3151358" y="3557217"/>
            <a:ext cx="1998100" cy="2745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effectLst/>
                <a:ea typeface="宋体" panose="02010600030101010101" pitchFamily="2" charset="-122"/>
              </a:rPr>
              <a:t>B:SUL model</a:t>
            </a:r>
            <a:endParaRPr lang="zh-CN" altLang="en-US" sz="12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5FEBB33-3DE0-444D-8BCA-FBE7F6F61112}"/>
              </a:ext>
            </a:extLst>
          </p:cNvPr>
          <p:cNvSpPr txBox="1"/>
          <p:nvPr/>
        </p:nvSpPr>
        <p:spPr>
          <a:xfrm>
            <a:off x="133292" y="5155997"/>
            <a:ext cx="60590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000" i="1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Note. P</a:t>
            </a:r>
            <a:r>
              <a:rPr lang="en-US" altLang="zh-CN" sz="1000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  refers to the significance for Delong test</a:t>
            </a:r>
            <a:r>
              <a:rPr lang="en-US" altLang="zh-CN" sz="1000" kern="100" dirty="0">
                <a:ea typeface="仿宋" panose="02010609060101010101" pitchFamily="49" charset="-122"/>
                <a:cs typeface="Times New Roman" panose="02020603050405020304" pitchFamily="18" charset="0"/>
              </a:rPr>
              <a:t>.</a:t>
            </a:r>
            <a:endParaRPr lang="zh-CN" altLang="zh-CN" sz="10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40520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04B88C8-7998-47D4-8C7D-8A0BA099114E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996010" y="1041260"/>
            <a:ext cx="2755546" cy="274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D22934B-1856-4FE4-92E9-7FF4DE3C7DB2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58307" y="1047686"/>
            <a:ext cx="2743200" cy="2743200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09DA023-F012-44B0-A686-5048036522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4068466"/>
              </p:ext>
            </p:extLst>
          </p:nvPr>
        </p:nvGraphicFramePr>
        <p:xfrm>
          <a:off x="44058" y="4177143"/>
          <a:ext cx="6074190" cy="90108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27026">
                  <a:extLst>
                    <a:ext uri="{9D8B030D-6E8A-4147-A177-3AD203B41FA5}">
                      <a16:colId xmlns:a16="http://schemas.microsoft.com/office/drawing/2014/main" val="3977183989"/>
                    </a:ext>
                  </a:extLst>
                </a:gridCol>
                <a:gridCol w="822389">
                  <a:extLst>
                    <a:ext uri="{9D8B030D-6E8A-4147-A177-3AD203B41FA5}">
                      <a16:colId xmlns:a16="http://schemas.microsoft.com/office/drawing/2014/main" val="3788521263"/>
                    </a:ext>
                  </a:extLst>
                </a:gridCol>
                <a:gridCol w="796636">
                  <a:extLst>
                    <a:ext uri="{9D8B030D-6E8A-4147-A177-3AD203B41FA5}">
                      <a16:colId xmlns:a16="http://schemas.microsoft.com/office/drawing/2014/main" val="402062983"/>
                    </a:ext>
                  </a:extLst>
                </a:gridCol>
                <a:gridCol w="491836">
                  <a:extLst>
                    <a:ext uri="{9D8B030D-6E8A-4147-A177-3AD203B41FA5}">
                      <a16:colId xmlns:a16="http://schemas.microsoft.com/office/drawing/2014/main" val="823541215"/>
                    </a:ext>
                  </a:extLst>
                </a:gridCol>
                <a:gridCol w="464128">
                  <a:extLst>
                    <a:ext uri="{9D8B030D-6E8A-4147-A177-3AD203B41FA5}">
                      <a16:colId xmlns:a16="http://schemas.microsoft.com/office/drawing/2014/main" val="3005948740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162227583"/>
                    </a:ext>
                  </a:extLst>
                </a:gridCol>
                <a:gridCol w="638775">
                  <a:extLst>
                    <a:ext uri="{9D8B030D-6E8A-4147-A177-3AD203B41FA5}">
                      <a16:colId xmlns:a16="http://schemas.microsoft.com/office/drawing/2014/main" val="2643753764"/>
                    </a:ext>
                  </a:extLst>
                </a:gridCol>
              </a:tblGrid>
              <a:tr h="376711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Model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Sensitivity</a:t>
                      </a:r>
                      <a:r>
                        <a:rPr lang="zh-CN" sz="1200" kern="100" dirty="0">
                          <a:effectLst/>
                        </a:rPr>
                        <a:t>（</a:t>
                      </a:r>
                      <a:r>
                        <a:rPr lang="en-US" sz="1200" kern="100" dirty="0">
                          <a:effectLst/>
                        </a:rPr>
                        <a:t>%</a:t>
                      </a:r>
                      <a:r>
                        <a:rPr lang="zh-CN" sz="1200" kern="10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Specificity</a:t>
                      </a:r>
                      <a:r>
                        <a:rPr lang="zh-CN" sz="1200" kern="100" dirty="0">
                          <a:effectLst/>
                        </a:rPr>
                        <a:t>（</a:t>
                      </a:r>
                      <a:r>
                        <a:rPr lang="en-US" sz="1200" kern="100" dirty="0">
                          <a:effectLst/>
                        </a:rPr>
                        <a:t>%</a:t>
                      </a:r>
                      <a:r>
                        <a:rPr lang="zh-CN" sz="1200" kern="10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>
                          <a:effectLst/>
                        </a:rPr>
                        <a:t>PPV</a:t>
                      </a:r>
                      <a:r>
                        <a:rPr lang="zh-CN" sz="1200" kern="100">
                          <a:effectLst/>
                        </a:rPr>
                        <a:t>（</a:t>
                      </a:r>
                      <a:r>
                        <a:rPr lang="en-US" sz="1200" kern="100">
                          <a:effectLst/>
                        </a:rPr>
                        <a:t>%</a:t>
                      </a:r>
                      <a:r>
                        <a:rPr lang="zh-CN" sz="1200" kern="100">
                          <a:effectLst/>
                        </a:rPr>
                        <a:t>）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NPV</a:t>
                      </a:r>
                      <a:r>
                        <a:rPr lang="zh-CN" sz="1200" kern="100" dirty="0">
                          <a:effectLst/>
                        </a:rPr>
                        <a:t>（</a:t>
                      </a:r>
                      <a:r>
                        <a:rPr lang="en-US" sz="1200" kern="100" dirty="0">
                          <a:effectLst/>
                        </a:rPr>
                        <a:t>%</a:t>
                      </a:r>
                      <a:r>
                        <a:rPr lang="zh-CN" sz="1200" kern="100" dirty="0">
                          <a:effectLst/>
                        </a:rPr>
                        <a:t>）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AUC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kern="100" dirty="0">
                          <a:effectLst/>
                          <a:latin typeface="Calibri" panose="020F0502020204030204" pitchFamily="34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 valu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25372326"/>
                  </a:ext>
                </a:extLst>
              </a:tr>
              <a:tr h="255065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SUL model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63.64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85.7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77.8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75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0.727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kern="100" dirty="0">
                          <a:effectLst/>
                          <a:latin typeface="Calibri" panose="020F0502020204030204" pitchFamily="34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33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97570159"/>
                  </a:ext>
                </a:extLst>
              </a:tr>
              <a:tr h="269312"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PET/CT texture parameter model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63.64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92.86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87.5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76.5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kern="100" dirty="0">
                          <a:effectLst/>
                        </a:rPr>
                        <a:t>0.792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kern="100" dirty="0">
                          <a:effectLst/>
                          <a:latin typeface="Calibri" panose="020F0502020204030204" pitchFamily="34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049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26607604"/>
                  </a:ext>
                </a:extLst>
              </a:tr>
            </a:tbl>
          </a:graphicData>
        </a:graphic>
      </p:graphicFrame>
      <p:pic>
        <p:nvPicPr>
          <p:cNvPr id="5" name="Picture 1">
            <a:extLst>
              <a:ext uri="{FF2B5EF4-FFF2-40B4-BE49-F238E27FC236}">
                <a16:creationId xmlns:a16="http://schemas.microsoft.com/office/drawing/2014/main" id="{B9075C84-F018-49C3-91EC-96FFB714C69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250" y="4798182"/>
            <a:ext cx="3940150" cy="85759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65CBC50-0204-4BD6-AFBA-A9DFCD6E1E91}"/>
              </a:ext>
            </a:extLst>
          </p:cNvPr>
          <p:cNvSpPr txBox="1"/>
          <p:nvPr/>
        </p:nvSpPr>
        <p:spPr>
          <a:xfrm>
            <a:off x="591395" y="3794081"/>
            <a:ext cx="16758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dirty="0">
                <a:effectLst/>
                <a:ea typeface="宋体" panose="02010600030101010101" pitchFamily="2" charset="-122"/>
              </a:rPr>
              <a:t>SUL model</a:t>
            </a:r>
            <a:endParaRPr lang="zh-CN" altLang="en-US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2BBFBCA-7134-4233-9805-DB80B6543E93}"/>
              </a:ext>
            </a:extLst>
          </p:cNvPr>
          <p:cNvSpPr txBox="1"/>
          <p:nvPr/>
        </p:nvSpPr>
        <p:spPr>
          <a:xfrm>
            <a:off x="2800323" y="3750315"/>
            <a:ext cx="36238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kern="100" dirty="0">
                <a:effectLst/>
                <a:ea typeface="宋体" panose="02010600030101010101" pitchFamily="2" charset="-122"/>
              </a:rPr>
              <a:t>PET / CT </a:t>
            </a:r>
            <a:r>
              <a:rPr lang="en-US" altLang="zh-CN" b="1" kern="100" dirty="0" err="1">
                <a:effectLst/>
              </a:rPr>
              <a:t>textureparameter</a:t>
            </a:r>
            <a:r>
              <a:rPr lang="en-US" altLang="zh-CN" b="1" kern="100" dirty="0">
                <a:effectLst/>
              </a:rPr>
              <a:t> </a:t>
            </a:r>
            <a:r>
              <a:rPr lang="en-US" altLang="zh-CN" b="1" kern="100" dirty="0">
                <a:effectLst/>
                <a:ea typeface="宋体" panose="02010600030101010101" pitchFamily="2" charset="-122"/>
              </a:rPr>
              <a:t>model</a:t>
            </a:r>
            <a:endParaRPr lang="zh-CN" altLang="en-US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DA838E0-4D56-42EE-AAA8-635BC4E65D66}"/>
              </a:ext>
            </a:extLst>
          </p:cNvPr>
          <p:cNvSpPr txBox="1"/>
          <p:nvPr/>
        </p:nvSpPr>
        <p:spPr>
          <a:xfrm>
            <a:off x="44059" y="121297"/>
            <a:ext cx="10014341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b="1" dirty="0">
                <a:cs typeface="Times New Roman" panose="02020603050405020304" pitchFamily="18" charset="0"/>
              </a:rPr>
              <a:t>The SUL model and </a:t>
            </a:r>
            <a:r>
              <a:rPr lang="en-US" altLang="zh-CN" sz="2800" b="1" kern="100" dirty="0">
                <a:effectLst/>
                <a:cs typeface="Times New Roman" panose="02020603050405020304" pitchFamily="18" charset="0"/>
              </a:rPr>
              <a:t>PET/CT texture parameter combination model</a:t>
            </a:r>
            <a:endParaRPr lang="zh-CN" altLang="zh-CN" sz="2800" b="1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2800" b="1" dirty="0">
                <a:cs typeface="Times New Roman" panose="02020603050405020304" pitchFamily="18" charset="0"/>
              </a:rPr>
              <a:t> were prospectively verified</a:t>
            </a:r>
            <a:endParaRPr lang="zh-CN" altLang="en-US" sz="2800" b="1" dirty="0"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7578702-4033-4E83-9807-3AD642DA3305}"/>
              </a:ext>
            </a:extLst>
          </p:cNvPr>
          <p:cNvSpPr txBox="1"/>
          <p:nvPr/>
        </p:nvSpPr>
        <p:spPr>
          <a:xfrm>
            <a:off x="6117656" y="1374061"/>
            <a:ext cx="3623895" cy="30469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2400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PET/CT texture parameter models can improve the prediction ability of </a:t>
            </a:r>
            <a:r>
              <a:rPr lang="en-US" altLang="zh-CN" sz="2400" kern="100" dirty="0" err="1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ccRCC</a:t>
            </a:r>
            <a:r>
              <a:rPr lang="en-US" altLang="zh-CN" sz="2400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 Fuhrman nuclear grade; SUL model may be the more accurate and easiest way to predict </a:t>
            </a:r>
            <a:r>
              <a:rPr lang="en-US" altLang="zh-CN" sz="2400" kern="100" dirty="0" err="1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ccRCC</a:t>
            </a:r>
            <a:r>
              <a:rPr lang="en-US" altLang="zh-CN" sz="2400" kern="100" dirty="0">
                <a:effectLst/>
                <a:ea typeface="宋体" panose="02010600030101010101" pitchFamily="2" charset="-122"/>
                <a:cs typeface="Times New Roman" panose="02020603050405020304" pitchFamily="18" charset="0"/>
              </a:rPr>
              <a:t> Fuhrman nuclear grade.</a:t>
            </a:r>
            <a:endParaRPr lang="zh-CN" altLang="zh-CN" sz="24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F210672-F922-413C-9E11-C7C71182E638}"/>
              </a:ext>
            </a:extLst>
          </p:cNvPr>
          <p:cNvSpPr txBox="1"/>
          <p:nvPr/>
        </p:nvSpPr>
        <p:spPr>
          <a:xfrm>
            <a:off x="6036760" y="902067"/>
            <a:ext cx="519248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kern="100" dirty="0">
                <a:solidFill>
                  <a:srgbClr val="FF0000"/>
                </a:solidFill>
                <a:effectLst/>
                <a:ea typeface="宋体" panose="02010600030101010101" pitchFamily="2" charset="-122"/>
              </a:rPr>
              <a:t>Conclusions</a:t>
            </a:r>
            <a:endParaRPr lang="zh-CN" altLang="en-US" sz="2400" dirty="0">
              <a:solidFill>
                <a:srgbClr val="FF0000"/>
              </a:solidFill>
            </a:endParaRPr>
          </a:p>
        </p:txBody>
      </p:sp>
      <p:sp>
        <p:nvSpPr>
          <p:cNvPr id="17" name="TextBox 9">
            <a:extLst>
              <a:ext uri="{FF2B5EF4-FFF2-40B4-BE49-F238E27FC236}">
                <a16:creationId xmlns:a16="http://schemas.microsoft.com/office/drawing/2014/main" id="{E09AA8EA-D406-4ABC-A3BD-FD2CECB4B891}"/>
              </a:ext>
            </a:extLst>
          </p:cNvPr>
          <p:cNvSpPr txBox="1"/>
          <p:nvPr/>
        </p:nvSpPr>
        <p:spPr>
          <a:xfrm>
            <a:off x="44059" y="5286440"/>
            <a:ext cx="24340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Zhang </a:t>
            </a:r>
            <a:r>
              <a:rPr lang="en-US" altLang="zh-CN" dirty="0" err="1"/>
              <a:t>linhan</a:t>
            </a:r>
            <a:r>
              <a:rPr lang="en-US" altLang="zh-CN" dirty="0"/>
              <a:t> </a:t>
            </a:r>
            <a:r>
              <a:rPr lang="en-US" dirty="0"/>
              <a:t>et al; 2021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6EA6929-C899-40EB-BDC5-941BFDD63507}"/>
              </a:ext>
            </a:extLst>
          </p:cNvPr>
          <p:cNvSpPr txBox="1"/>
          <p:nvPr/>
        </p:nvSpPr>
        <p:spPr>
          <a:xfrm>
            <a:off x="84824" y="5120780"/>
            <a:ext cx="582237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000" i="1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Note. P</a:t>
            </a:r>
            <a:r>
              <a:rPr lang="en-US" altLang="zh-CN" sz="1000" kern="100" dirty="0">
                <a:effectLst/>
                <a:ea typeface="仿宋" panose="02010609060101010101" pitchFamily="49" charset="-122"/>
                <a:cs typeface="Times New Roman" panose="02020603050405020304" pitchFamily="18" charset="0"/>
              </a:rPr>
              <a:t>  refers to the significance for ROC curves</a:t>
            </a:r>
            <a:r>
              <a:rPr lang="en-US" altLang="zh-CN" sz="1000" kern="100" dirty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.</a:t>
            </a:r>
            <a:endParaRPr lang="zh-CN" altLang="zh-CN" sz="10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88098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7</TotalTime>
  <Words>902</Words>
  <Application>Microsoft Office PowerPoint</Application>
  <PresentationFormat>自定义</PresentationFormat>
  <Paragraphs>256</Paragraphs>
  <Slides>6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Times New Roman</vt:lpstr>
      <vt:lpstr>Wingdings</vt:lpstr>
      <vt:lpstr>Office Theme</vt:lpstr>
      <vt:lpstr>PowerPoint 演示文稿</vt:lpstr>
      <vt:lpstr>Differences of conventional PET parameters in the Fuhrman grades of ccRCC </vt:lpstr>
      <vt:lpstr>The ability of a single texture features to distinguish the grade of clear cell carcinoma</vt:lpstr>
      <vt:lpstr>Comparison of the difference in diagnostic ability between the radiomic variable prediction models and the SUV models</vt:lpstr>
      <vt:lpstr>PowerPoint 演示文稿</vt:lpstr>
      <vt:lpstr>PowerPoint 演示文稿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ok,Olga R. (HMFP - Radiology)</dc:creator>
  <cp:lastModifiedBy>Linhan Zhang</cp:lastModifiedBy>
  <cp:revision>48</cp:revision>
  <dcterms:created xsi:type="dcterms:W3CDTF">2020-06-22T01:49:04Z</dcterms:created>
  <dcterms:modified xsi:type="dcterms:W3CDTF">2021-08-03T10:08:25Z</dcterms:modified>
</cp:coreProperties>
</file>